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75" autoAdjust="0"/>
    <p:restoredTop sz="99839" autoAdjust="0"/>
  </p:normalViewPr>
  <p:slideViewPr>
    <p:cSldViewPr snapToGrid="0" snapToObjects="1">
      <p:cViewPr>
        <p:scale>
          <a:sx n="116" d="100"/>
          <a:sy n="116" d="100"/>
        </p:scale>
        <p:origin x="-136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5F091-32BD-4AEC-91F0-B670B582AAD3}" type="datetimeFigureOut">
              <a:rPr lang="en-US" smtClean="0"/>
              <a:pPr/>
              <a:t>2015-01-2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ACFF2B-1323-4A49-8E45-531768F90A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598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Distal: D7-3 distal-2</a:t>
            </a:r>
          </a:p>
          <a:p>
            <a:r>
              <a:rPr lang="en-US" dirty="0" smtClean="0"/>
              <a:t>Invasive</a:t>
            </a:r>
            <a:r>
              <a:rPr lang="en-US" baseline="0" dirty="0" smtClean="0"/>
              <a:t> front: D7-6 tum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ACFF2B-1323-4A49-8E45-531768F90A2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012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9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6671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721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0424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7760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166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7017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9478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4712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1082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4ADAC-74A1-244D-BDE5-7F9C4D942866}" type="datetimeFigureOut">
              <a:rPr lang="fr-FR" smtClean="0"/>
              <a:pPr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2DE5C-C81C-AC48-8E49-68FCE4084BB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69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7.png"/><Relationship Id="rId1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Relationship Id="rId4" Type="http://schemas.microsoft.com/office/2007/relationships/hdphoto" Target="../media/hdphoto1.wdp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6.jpeg"/><Relationship Id="rId10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ZoneTexte 283"/>
          <p:cNvSpPr txBox="1"/>
          <p:nvPr/>
        </p:nvSpPr>
        <p:spPr>
          <a:xfrm>
            <a:off x="4342721" y="116203"/>
            <a:ext cx="479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D7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17" name="Triangle isocèle 61"/>
          <p:cNvSpPr/>
          <p:nvPr/>
        </p:nvSpPr>
        <p:spPr>
          <a:xfrm>
            <a:off x="6136953" y="385810"/>
            <a:ext cx="45273" cy="56954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fr-FR">
              <a:latin typeface="Arial"/>
              <a:cs typeface="Arial"/>
            </a:endParaRPr>
          </a:p>
        </p:txBody>
      </p:sp>
      <p:grpSp>
        <p:nvGrpSpPr>
          <p:cNvPr id="7" name="Grouper 6"/>
          <p:cNvGrpSpPr/>
          <p:nvPr/>
        </p:nvGrpSpPr>
        <p:grpSpPr>
          <a:xfrm>
            <a:off x="4739371" y="385810"/>
            <a:ext cx="1993869" cy="2402001"/>
            <a:chOff x="4722122" y="385810"/>
            <a:chExt cx="1993869" cy="2402001"/>
          </a:xfrm>
        </p:grpSpPr>
        <p:sp>
          <p:nvSpPr>
            <p:cNvPr id="47" name="ZoneTexte 70"/>
            <p:cNvSpPr txBox="1"/>
            <p:nvPr/>
          </p:nvSpPr>
          <p:spPr>
            <a:xfrm>
              <a:off x="5372104" y="385810"/>
              <a:ext cx="8515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  <a:latin typeface="Arial"/>
                  <a:cs typeface="Arial"/>
                </a:rPr>
                <a:t>MMP9</a:t>
              </a:r>
              <a:endParaRPr lang="fr-FR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2122" y="695643"/>
              <a:ext cx="1993869" cy="20921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6" name="Triangle isocèle 12"/>
            <p:cNvSpPr/>
            <p:nvPr/>
          </p:nvSpPr>
          <p:spPr>
            <a:xfrm>
              <a:off x="5758320" y="1615678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sp>
          <p:nvSpPr>
            <p:cNvPr id="118" name="Triangle isocèle 62"/>
            <p:cNvSpPr/>
            <p:nvPr/>
          </p:nvSpPr>
          <p:spPr>
            <a:xfrm flipV="1">
              <a:off x="5744736" y="1337450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sp>
          <p:nvSpPr>
            <p:cNvPr id="119" name="Triangle isocèle 63"/>
            <p:cNvSpPr/>
            <p:nvPr/>
          </p:nvSpPr>
          <p:spPr>
            <a:xfrm flipV="1">
              <a:off x="5187739" y="2053561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sp>
          <p:nvSpPr>
            <p:cNvPr id="120" name="Triangle isocèle 64"/>
            <p:cNvSpPr/>
            <p:nvPr/>
          </p:nvSpPr>
          <p:spPr>
            <a:xfrm flipV="1">
              <a:off x="5949816" y="2387783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sp>
          <p:nvSpPr>
            <p:cNvPr id="154" name="Rectangle 153"/>
            <p:cNvSpPr/>
            <p:nvPr/>
          </p:nvSpPr>
          <p:spPr>
            <a:xfrm>
              <a:off x="4722122" y="695643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  <a:latin typeface="Arial"/>
                <a:cs typeface="Arial"/>
              </a:endParaRPr>
            </a:p>
          </p:txBody>
        </p:sp>
        <p:sp>
          <p:nvSpPr>
            <p:cNvPr id="126" name="Triangle isocèle 63"/>
            <p:cNvSpPr/>
            <p:nvPr/>
          </p:nvSpPr>
          <p:spPr>
            <a:xfrm flipV="1">
              <a:off x="5543899" y="2172001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sp>
          <p:nvSpPr>
            <p:cNvPr id="127" name="Triangle isocèle 61"/>
            <p:cNvSpPr/>
            <p:nvPr/>
          </p:nvSpPr>
          <p:spPr>
            <a:xfrm>
              <a:off x="6194265" y="1888418"/>
              <a:ext cx="45273" cy="56954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</p:grpSp>
      <p:grpSp>
        <p:nvGrpSpPr>
          <p:cNvPr id="5" name="Grouper 4"/>
          <p:cNvGrpSpPr/>
          <p:nvPr/>
        </p:nvGrpSpPr>
        <p:grpSpPr>
          <a:xfrm>
            <a:off x="468864" y="385810"/>
            <a:ext cx="2051652" cy="2421958"/>
            <a:chOff x="468864" y="385810"/>
            <a:chExt cx="2051652" cy="2421958"/>
          </a:xfrm>
        </p:grpSpPr>
        <p:sp>
          <p:nvSpPr>
            <p:cNvPr id="46" name="ZoneTexte 15"/>
            <p:cNvSpPr txBox="1"/>
            <p:nvPr/>
          </p:nvSpPr>
          <p:spPr>
            <a:xfrm>
              <a:off x="1026498" y="385810"/>
              <a:ext cx="847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8000"/>
                  </a:solidFill>
                  <a:latin typeface="Arial"/>
                  <a:cs typeface="Arial"/>
                </a:rPr>
                <a:t>Cd11b</a:t>
              </a:r>
              <a:endParaRPr lang="fr-FR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cxnSp>
          <p:nvCxnSpPr>
            <p:cNvPr id="53" name="Connecteur droit avec flèche 52"/>
            <p:cNvCxnSpPr/>
            <p:nvPr/>
          </p:nvCxnSpPr>
          <p:spPr>
            <a:xfrm>
              <a:off x="1948437" y="164038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avec flèche 53"/>
            <p:cNvCxnSpPr/>
            <p:nvPr/>
          </p:nvCxnSpPr>
          <p:spPr>
            <a:xfrm>
              <a:off x="1504674" y="1255168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eur droit avec flèche 54"/>
            <p:cNvCxnSpPr/>
            <p:nvPr/>
          </p:nvCxnSpPr>
          <p:spPr>
            <a:xfrm>
              <a:off x="1710120" y="235145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avec flèche 55"/>
            <p:cNvCxnSpPr/>
            <p:nvPr/>
          </p:nvCxnSpPr>
          <p:spPr>
            <a:xfrm>
              <a:off x="920033" y="2008232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avec flèche 56"/>
            <p:cNvCxnSpPr/>
            <p:nvPr/>
          </p:nvCxnSpPr>
          <p:spPr>
            <a:xfrm flipV="1">
              <a:off x="1494691" y="158830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avec flèche 57"/>
            <p:cNvCxnSpPr/>
            <p:nvPr/>
          </p:nvCxnSpPr>
          <p:spPr>
            <a:xfrm flipV="1">
              <a:off x="1896189" y="930534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avec flèche 58"/>
            <p:cNvCxnSpPr/>
            <p:nvPr/>
          </p:nvCxnSpPr>
          <p:spPr>
            <a:xfrm>
              <a:off x="1896189" y="150792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9" name="Group 98"/>
            <p:cNvGrpSpPr/>
            <p:nvPr/>
          </p:nvGrpSpPr>
          <p:grpSpPr>
            <a:xfrm>
              <a:off x="468864" y="695643"/>
              <a:ext cx="2051652" cy="2112125"/>
              <a:chOff x="3480827" y="763591"/>
              <a:chExt cx="2611139" cy="2605137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3480827" y="763591"/>
                <a:ext cx="2611139" cy="2605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84" name="Connecteur droit avec flèche 52"/>
              <p:cNvCxnSpPr/>
              <p:nvPr/>
            </p:nvCxnSpPr>
            <p:spPr>
              <a:xfrm>
                <a:off x="5440936" y="1940200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avec flèche 53"/>
              <p:cNvCxnSpPr/>
              <p:nvPr/>
            </p:nvCxnSpPr>
            <p:spPr>
              <a:xfrm>
                <a:off x="4858871" y="1465069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avec flèche 54"/>
              <p:cNvCxnSpPr/>
              <p:nvPr/>
            </p:nvCxnSpPr>
            <p:spPr>
              <a:xfrm>
                <a:off x="5120342" y="2817248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avec flèche 55"/>
              <p:cNvCxnSpPr/>
              <p:nvPr/>
            </p:nvCxnSpPr>
            <p:spPr>
              <a:xfrm>
                <a:off x="4114798" y="2393913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avec flèche 56"/>
              <p:cNvCxnSpPr/>
              <p:nvPr/>
            </p:nvCxnSpPr>
            <p:spPr>
              <a:xfrm flipV="1">
                <a:off x="4846165" y="1875964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cteur droit avec flèche 57"/>
              <p:cNvCxnSpPr/>
              <p:nvPr/>
            </p:nvCxnSpPr>
            <p:spPr>
              <a:xfrm flipV="1">
                <a:off x="5357153" y="1064658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avec flèche 58"/>
              <p:cNvCxnSpPr/>
              <p:nvPr/>
            </p:nvCxnSpPr>
            <p:spPr>
              <a:xfrm>
                <a:off x="5357153" y="1776822"/>
                <a:ext cx="0" cy="179294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2" name="Connecteur droit avec flèche 25"/>
            <p:cNvCxnSpPr/>
            <p:nvPr/>
          </p:nvCxnSpPr>
          <p:spPr>
            <a:xfrm>
              <a:off x="1195958" y="1265816"/>
              <a:ext cx="0" cy="14709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cteur droit avec flèche 55"/>
            <p:cNvCxnSpPr/>
            <p:nvPr/>
          </p:nvCxnSpPr>
          <p:spPr>
            <a:xfrm>
              <a:off x="1329946" y="2088329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cteur droit avec flèche 59"/>
            <p:cNvCxnSpPr/>
            <p:nvPr/>
          </p:nvCxnSpPr>
          <p:spPr>
            <a:xfrm flipV="1">
              <a:off x="2096528" y="2071115"/>
              <a:ext cx="0" cy="14709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cteur droit avec flèche 57"/>
            <p:cNvCxnSpPr/>
            <p:nvPr/>
          </p:nvCxnSpPr>
          <p:spPr>
            <a:xfrm flipV="1">
              <a:off x="1253343" y="1031006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er 5"/>
          <p:cNvGrpSpPr/>
          <p:nvPr/>
        </p:nvGrpSpPr>
        <p:grpSpPr>
          <a:xfrm>
            <a:off x="2642713" y="385810"/>
            <a:ext cx="1974461" cy="2410634"/>
            <a:chOff x="2631800" y="385810"/>
            <a:chExt cx="1974461" cy="2410634"/>
          </a:xfrm>
        </p:grpSpPr>
        <p:sp>
          <p:nvSpPr>
            <p:cNvPr id="45" name="ZoneTexte 69"/>
            <p:cNvSpPr txBox="1"/>
            <p:nvPr/>
          </p:nvSpPr>
          <p:spPr>
            <a:xfrm>
              <a:off x="3223703" y="385810"/>
              <a:ext cx="8046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chemeClr val="accent4">
                      <a:lumMod val="75000"/>
                    </a:schemeClr>
                  </a:solidFill>
                  <a:latin typeface="Arial"/>
                  <a:cs typeface="Arial"/>
                </a:rPr>
                <a:t>Ly-6G</a:t>
              </a:r>
              <a:endParaRPr lang="fr-FR" dirty="0">
                <a:solidFill>
                  <a:schemeClr val="accent4">
                    <a:lumMod val="75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62" name="Triangle isocèle 61"/>
            <p:cNvSpPr/>
            <p:nvPr/>
          </p:nvSpPr>
          <p:spPr>
            <a:xfrm>
              <a:off x="4036069" y="385810"/>
              <a:ext cx="44681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latin typeface="Arial"/>
                <a:cs typeface="Arial"/>
              </a:endParaRPr>
            </a:p>
          </p:txBody>
        </p:sp>
        <p:grpSp>
          <p:nvGrpSpPr>
            <p:cNvPr id="4" name="Grouper 3"/>
            <p:cNvGrpSpPr/>
            <p:nvPr/>
          </p:nvGrpSpPr>
          <p:grpSpPr>
            <a:xfrm>
              <a:off x="2631800" y="695645"/>
              <a:ext cx="1974461" cy="2100799"/>
              <a:chOff x="2631800" y="695645"/>
              <a:chExt cx="1974461" cy="2100799"/>
            </a:xfrm>
          </p:grpSpPr>
          <p:cxnSp>
            <p:nvCxnSpPr>
              <p:cNvPr id="3" name="Connecteur droit avec flèche 2"/>
              <p:cNvCxnSpPr/>
              <p:nvPr/>
            </p:nvCxnSpPr>
            <p:spPr>
              <a:xfrm>
                <a:off x="4099245" y="1632082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5"/>
              <p:cNvCxnSpPr/>
              <p:nvPr/>
            </p:nvCxnSpPr>
            <p:spPr>
              <a:xfrm>
                <a:off x="3663756" y="1242274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avec flèche 30"/>
              <p:cNvCxnSpPr/>
              <p:nvPr/>
            </p:nvCxnSpPr>
            <p:spPr>
              <a:xfrm>
                <a:off x="3865371" y="2351630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avec flèche 31"/>
              <p:cNvCxnSpPr/>
              <p:nvPr/>
            </p:nvCxnSpPr>
            <p:spPr>
              <a:xfrm>
                <a:off x="3090014" y="2004317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cteur droit avec flèche 32"/>
              <p:cNvCxnSpPr/>
              <p:nvPr/>
            </p:nvCxnSpPr>
            <p:spPr>
              <a:xfrm flipV="1">
                <a:off x="3653958" y="1579381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avec flèche 33"/>
              <p:cNvCxnSpPr/>
              <p:nvPr/>
            </p:nvCxnSpPr>
            <p:spPr>
              <a:xfrm flipV="1">
                <a:off x="4047972" y="913768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avec flèche 34"/>
              <p:cNvCxnSpPr/>
              <p:nvPr/>
            </p:nvCxnSpPr>
            <p:spPr>
              <a:xfrm>
                <a:off x="4047972" y="1498043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avec flèche 59"/>
              <p:cNvCxnSpPr/>
              <p:nvPr/>
            </p:nvCxnSpPr>
            <p:spPr>
              <a:xfrm flipV="1">
                <a:off x="4186223" y="2081117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riangle isocèle 12"/>
              <p:cNvSpPr/>
              <p:nvPr/>
            </p:nvSpPr>
            <p:spPr>
              <a:xfrm>
                <a:off x="3654193" y="1596508"/>
                <a:ext cx="44681" cy="59806"/>
              </a:xfrm>
              <a:prstGeom prst="triangl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>
                  <a:latin typeface="Arial"/>
                  <a:cs typeface="Arial"/>
                </a:endParaRPr>
              </a:p>
            </p:txBody>
          </p:sp>
          <p:sp>
            <p:nvSpPr>
              <p:cNvPr id="63" name="Triangle isocèle 62"/>
              <p:cNvSpPr/>
              <p:nvPr/>
            </p:nvSpPr>
            <p:spPr>
              <a:xfrm flipV="1">
                <a:off x="3669086" y="1352625"/>
                <a:ext cx="44681" cy="59806"/>
              </a:xfrm>
              <a:prstGeom prst="triangl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>
                  <a:latin typeface="Arial"/>
                  <a:cs typeface="Arial"/>
                </a:endParaRPr>
              </a:p>
            </p:txBody>
          </p:sp>
          <p:sp>
            <p:nvSpPr>
              <p:cNvPr id="64" name="Triangle isocèle 63"/>
              <p:cNvSpPr/>
              <p:nvPr/>
            </p:nvSpPr>
            <p:spPr>
              <a:xfrm flipV="1">
                <a:off x="3079148" y="2073193"/>
                <a:ext cx="44681" cy="59806"/>
              </a:xfrm>
              <a:prstGeom prst="triangl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>
                  <a:latin typeface="Arial"/>
                  <a:cs typeface="Arial"/>
                </a:endParaRPr>
              </a:p>
            </p:txBody>
          </p:sp>
          <p:sp>
            <p:nvSpPr>
              <p:cNvPr id="65" name="Triangle isocèle 64"/>
              <p:cNvSpPr/>
              <p:nvPr/>
            </p:nvSpPr>
            <p:spPr>
              <a:xfrm flipV="1">
                <a:off x="3849146" y="2454058"/>
                <a:ext cx="44681" cy="59806"/>
              </a:xfrm>
              <a:prstGeom prst="triangl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>
                  <a:latin typeface="Arial"/>
                  <a:cs typeface="Arial"/>
                </a:endParaRP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2631800" y="695645"/>
                <a:ext cx="1974461" cy="21007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01" name="Connecteur droit avec flèche 2"/>
              <p:cNvCxnSpPr/>
              <p:nvPr/>
            </p:nvCxnSpPr>
            <p:spPr>
              <a:xfrm>
                <a:off x="4142013" y="1645139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avec flèche 25"/>
              <p:cNvCxnSpPr/>
              <p:nvPr/>
            </p:nvCxnSpPr>
            <p:spPr>
              <a:xfrm>
                <a:off x="3669086" y="1225904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cteur droit avec flèche 30"/>
              <p:cNvCxnSpPr/>
              <p:nvPr/>
            </p:nvCxnSpPr>
            <p:spPr>
              <a:xfrm>
                <a:off x="3846990" y="2326315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avec flèche 31"/>
              <p:cNvCxnSpPr/>
              <p:nvPr/>
            </p:nvCxnSpPr>
            <p:spPr>
              <a:xfrm>
                <a:off x="3071632" y="1979002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Connecteur droit avec flèche 32"/>
              <p:cNvCxnSpPr/>
              <p:nvPr/>
            </p:nvCxnSpPr>
            <p:spPr>
              <a:xfrm flipV="1">
                <a:off x="3669086" y="1578909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avec flèche 34"/>
              <p:cNvCxnSpPr/>
              <p:nvPr/>
            </p:nvCxnSpPr>
            <p:spPr>
              <a:xfrm>
                <a:off x="4063550" y="1472727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avec flèche 59"/>
              <p:cNvCxnSpPr/>
              <p:nvPr/>
            </p:nvCxnSpPr>
            <p:spPr>
              <a:xfrm flipV="1">
                <a:off x="4212522" y="2081117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avec flèche 25"/>
              <p:cNvCxnSpPr/>
              <p:nvPr/>
            </p:nvCxnSpPr>
            <p:spPr>
              <a:xfrm>
                <a:off x="3339254" y="1290008"/>
                <a:ext cx="0" cy="14709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avec flèche 55"/>
              <p:cNvCxnSpPr/>
              <p:nvPr/>
            </p:nvCxnSpPr>
            <p:spPr>
              <a:xfrm>
                <a:off x="3445108" y="2061406"/>
                <a:ext cx="0" cy="1453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Connecteur droit avec flèche 57"/>
              <p:cNvCxnSpPr/>
              <p:nvPr/>
            </p:nvCxnSpPr>
            <p:spPr>
              <a:xfrm flipV="1">
                <a:off x="3393477" y="1031006"/>
                <a:ext cx="0" cy="1453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/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" name="Grouper 11"/>
          <p:cNvGrpSpPr/>
          <p:nvPr/>
        </p:nvGrpSpPr>
        <p:grpSpPr>
          <a:xfrm>
            <a:off x="2596187" y="3839044"/>
            <a:ext cx="2001852" cy="2101650"/>
            <a:chOff x="2614557" y="3839044"/>
            <a:chExt cx="2001852" cy="2101650"/>
          </a:xfrm>
        </p:grpSpPr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614557" y="3839044"/>
              <a:ext cx="2001852" cy="20901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43" name="Connecteur droit avec flèche 75"/>
            <p:cNvCxnSpPr/>
            <p:nvPr/>
          </p:nvCxnSpPr>
          <p:spPr>
            <a:xfrm>
              <a:off x="2996279" y="542220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cteur droit avec flèche 76"/>
            <p:cNvCxnSpPr/>
            <p:nvPr/>
          </p:nvCxnSpPr>
          <p:spPr>
            <a:xfrm>
              <a:off x="2899094" y="4928466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cteur droit avec flèche 77"/>
            <p:cNvCxnSpPr/>
            <p:nvPr/>
          </p:nvCxnSpPr>
          <p:spPr>
            <a:xfrm>
              <a:off x="3521537" y="463111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cteur droit avec flèche 79"/>
            <p:cNvCxnSpPr/>
            <p:nvPr/>
          </p:nvCxnSpPr>
          <p:spPr>
            <a:xfrm>
              <a:off x="3482205" y="5382189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Connecteur droit avec flèche 80"/>
            <p:cNvCxnSpPr/>
            <p:nvPr/>
          </p:nvCxnSpPr>
          <p:spPr>
            <a:xfrm flipV="1">
              <a:off x="4345049" y="544038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cteur droit avec flèche 74"/>
            <p:cNvCxnSpPr/>
            <p:nvPr/>
          </p:nvCxnSpPr>
          <p:spPr>
            <a:xfrm>
              <a:off x="4458857" y="4935271"/>
              <a:ext cx="0" cy="14632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cteur droit avec flèche 76"/>
            <p:cNvCxnSpPr/>
            <p:nvPr/>
          </p:nvCxnSpPr>
          <p:spPr>
            <a:xfrm>
              <a:off x="2740502" y="5417826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cteur droit avec flèche 76"/>
            <p:cNvCxnSpPr/>
            <p:nvPr/>
          </p:nvCxnSpPr>
          <p:spPr>
            <a:xfrm>
              <a:off x="3281642" y="5498946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necteur droit avec flèche 78"/>
            <p:cNvCxnSpPr/>
            <p:nvPr/>
          </p:nvCxnSpPr>
          <p:spPr>
            <a:xfrm flipV="1">
              <a:off x="3803717" y="4702948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Connecteur droit avec flèche 78"/>
            <p:cNvCxnSpPr/>
            <p:nvPr/>
          </p:nvCxnSpPr>
          <p:spPr>
            <a:xfrm flipV="1">
              <a:off x="3162583" y="4560628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cteur droit avec flèche 78"/>
            <p:cNvCxnSpPr/>
            <p:nvPr/>
          </p:nvCxnSpPr>
          <p:spPr>
            <a:xfrm flipV="1">
              <a:off x="2810007" y="4168940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cteur droit avec flèche 80"/>
            <p:cNvCxnSpPr/>
            <p:nvPr/>
          </p:nvCxnSpPr>
          <p:spPr>
            <a:xfrm flipV="1">
              <a:off x="4167020" y="559278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Connecteur droit avec flèche 80"/>
            <p:cNvCxnSpPr/>
            <p:nvPr/>
          </p:nvCxnSpPr>
          <p:spPr>
            <a:xfrm flipV="1">
              <a:off x="4060260" y="579702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Connecteur droit avec flèche 74"/>
            <p:cNvCxnSpPr/>
            <p:nvPr/>
          </p:nvCxnSpPr>
          <p:spPr>
            <a:xfrm>
              <a:off x="3935466" y="537439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cteur droit avec flèche 74"/>
            <p:cNvCxnSpPr/>
            <p:nvPr/>
          </p:nvCxnSpPr>
          <p:spPr>
            <a:xfrm>
              <a:off x="3265033" y="515095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cteur droit avec flèche 74"/>
            <p:cNvCxnSpPr/>
            <p:nvPr/>
          </p:nvCxnSpPr>
          <p:spPr>
            <a:xfrm>
              <a:off x="3482205" y="400413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cteur droit avec flèche 74"/>
            <p:cNvCxnSpPr/>
            <p:nvPr/>
          </p:nvCxnSpPr>
          <p:spPr>
            <a:xfrm>
              <a:off x="3148680" y="407229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cteur droit avec flèche 74"/>
            <p:cNvCxnSpPr/>
            <p:nvPr/>
          </p:nvCxnSpPr>
          <p:spPr>
            <a:xfrm>
              <a:off x="3573214" y="568051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necteur droit avec flèche 78"/>
            <p:cNvCxnSpPr/>
            <p:nvPr/>
          </p:nvCxnSpPr>
          <p:spPr>
            <a:xfrm flipV="1">
              <a:off x="3515058" y="518020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Connecteur droit avec flèche 74"/>
            <p:cNvCxnSpPr/>
            <p:nvPr/>
          </p:nvCxnSpPr>
          <p:spPr>
            <a:xfrm>
              <a:off x="4107572" y="402045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Connecteur droit avec flèche 74"/>
            <p:cNvCxnSpPr/>
            <p:nvPr/>
          </p:nvCxnSpPr>
          <p:spPr>
            <a:xfrm>
              <a:off x="4117434" y="461349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necteur droit avec flèche 78"/>
            <p:cNvCxnSpPr/>
            <p:nvPr/>
          </p:nvCxnSpPr>
          <p:spPr>
            <a:xfrm flipV="1">
              <a:off x="3016949" y="4738948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er 10"/>
          <p:cNvGrpSpPr/>
          <p:nvPr/>
        </p:nvGrpSpPr>
        <p:grpSpPr>
          <a:xfrm>
            <a:off x="468864" y="3849034"/>
            <a:ext cx="2022760" cy="2090007"/>
            <a:chOff x="497756" y="3849034"/>
            <a:chExt cx="2022760" cy="2090007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497756" y="3849034"/>
              <a:ext cx="2022760" cy="20760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68" name="Connecteur droit avec flèche 75"/>
            <p:cNvCxnSpPr/>
            <p:nvPr/>
          </p:nvCxnSpPr>
          <p:spPr>
            <a:xfrm>
              <a:off x="867943" y="5433511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cteur droit avec flèche 76"/>
            <p:cNvCxnSpPr/>
            <p:nvPr/>
          </p:nvCxnSpPr>
          <p:spPr>
            <a:xfrm>
              <a:off x="783716" y="492681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cteur droit avec flèche 77"/>
            <p:cNvCxnSpPr/>
            <p:nvPr/>
          </p:nvCxnSpPr>
          <p:spPr>
            <a:xfrm>
              <a:off x="1406159" y="4629460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cteur droit avec flèche 79"/>
            <p:cNvCxnSpPr/>
            <p:nvPr/>
          </p:nvCxnSpPr>
          <p:spPr>
            <a:xfrm>
              <a:off x="1366827" y="5380536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cteur droit avec flèche 80"/>
            <p:cNvCxnSpPr/>
            <p:nvPr/>
          </p:nvCxnSpPr>
          <p:spPr>
            <a:xfrm flipV="1">
              <a:off x="2229671" y="5438731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Connecteur droit avec flèche 74"/>
            <p:cNvCxnSpPr/>
            <p:nvPr/>
          </p:nvCxnSpPr>
          <p:spPr>
            <a:xfrm>
              <a:off x="2382353" y="4933618"/>
              <a:ext cx="0" cy="14632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cteur droit avec flèche 76"/>
            <p:cNvCxnSpPr/>
            <p:nvPr/>
          </p:nvCxnSpPr>
          <p:spPr>
            <a:xfrm>
              <a:off x="1166264" y="5497293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cteur droit avec flèche 78"/>
            <p:cNvCxnSpPr/>
            <p:nvPr/>
          </p:nvCxnSpPr>
          <p:spPr>
            <a:xfrm flipV="1">
              <a:off x="1688339" y="4701295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Connecteur droit avec flèche 78"/>
            <p:cNvCxnSpPr/>
            <p:nvPr/>
          </p:nvCxnSpPr>
          <p:spPr>
            <a:xfrm flipV="1">
              <a:off x="1047205" y="4558975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avec flèche 78"/>
            <p:cNvCxnSpPr/>
            <p:nvPr/>
          </p:nvCxnSpPr>
          <p:spPr>
            <a:xfrm flipV="1">
              <a:off x="694629" y="416728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cteur droit avec flèche 80"/>
            <p:cNvCxnSpPr/>
            <p:nvPr/>
          </p:nvCxnSpPr>
          <p:spPr>
            <a:xfrm flipV="1">
              <a:off x="2051642" y="5591131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necteur droit avec flèche 80"/>
            <p:cNvCxnSpPr/>
            <p:nvPr/>
          </p:nvCxnSpPr>
          <p:spPr>
            <a:xfrm flipV="1">
              <a:off x="1944882" y="5795371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necteur droit avec flèche 74"/>
            <p:cNvCxnSpPr/>
            <p:nvPr/>
          </p:nvCxnSpPr>
          <p:spPr>
            <a:xfrm>
              <a:off x="1820088" y="5372740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cteur droit avec flèche 74"/>
            <p:cNvCxnSpPr/>
            <p:nvPr/>
          </p:nvCxnSpPr>
          <p:spPr>
            <a:xfrm>
              <a:off x="1149655" y="5149300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cteur droit avec flèche 74"/>
            <p:cNvCxnSpPr/>
            <p:nvPr/>
          </p:nvCxnSpPr>
          <p:spPr>
            <a:xfrm>
              <a:off x="1366827" y="400248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cteur droit avec flèche 74"/>
            <p:cNvCxnSpPr/>
            <p:nvPr/>
          </p:nvCxnSpPr>
          <p:spPr>
            <a:xfrm>
              <a:off x="1033302" y="407064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avec flèche 74"/>
            <p:cNvCxnSpPr/>
            <p:nvPr/>
          </p:nvCxnSpPr>
          <p:spPr>
            <a:xfrm>
              <a:off x="1457836" y="5678864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cteur droit avec flèche 78"/>
            <p:cNvCxnSpPr/>
            <p:nvPr/>
          </p:nvCxnSpPr>
          <p:spPr>
            <a:xfrm flipV="1">
              <a:off x="1399819" y="5179586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necteur droit avec flèche 74"/>
            <p:cNvCxnSpPr/>
            <p:nvPr/>
          </p:nvCxnSpPr>
          <p:spPr>
            <a:xfrm>
              <a:off x="2012013" y="402361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Connecteur droit avec flèche 74"/>
            <p:cNvCxnSpPr/>
            <p:nvPr/>
          </p:nvCxnSpPr>
          <p:spPr>
            <a:xfrm>
              <a:off x="2021875" y="4616657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onnecteur droit avec flèche 78"/>
            <p:cNvCxnSpPr/>
            <p:nvPr/>
          </p:nvCxnSpPr>
          <p:spPr>
            <a:xfrm flipV="1">
              <a:off x="901571" y="4737295"/>
              <a:ext cx="0" cy="14367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er 13"/>
          <p:cNvGrpSpPr/>
          <p:nvPr/>
        </p:nvGrpSpPr>
        <p:grpSpPr>
          <a:xfrm>
            <a:off x="4702602" y="3839043"/>
            <a:ext cx="2004713" cy="2090120"/>
            <a:chOff x="4690086" y="3839043"/>
            <a:chExt cx="2004713" cy="2090120"/>
          </a:xfrm>
        </p:grpSpPr>
        <p:sp>
          <p:nvSpPr>
            <p:cNvPr id="91" name="Triangle isocèle 90"/>
            <p:cNvSpPr/>
            <p:nvPr/>
          </p:nvSpPr>
          <p:spPr>
            <a:xfrm flipV="1">
              <a:off x="5086151" y="426452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2" name="Triangle isocèle 91"/>
            <p:cNvSpPr/>
            <p:nvPr/>
          </p:nvSpPr>
          <p:spPr>
            <a:xfrm>
              <a:off x="4722122" y="4041408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3" name="Triangle isocèle 92"/>
            <p:cNvSpPr/>
            <p:nvPr/>
          </p:nvSpPr>
          <p:spPr>
            <a:xfrm flipV="1">
              <a:off x="5205930" y="5140007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4" name="Triangle isocèle 93"/>
            <p:cNvSpPr/>
            <p:nvPr/>
          </p:nvSpPr>
          <p:spPr>
            <a:xfrm>
              <a:off x="5468531" y="5036298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5" name="Triangle isocèle 94"/>
            <p:cNvSpPr/>
            <p:nvPr/>
          </p:nvSpPr>
          <p:spPr>
            <a:xfrm flipV="1">
              <a:off x="5170379" y="5496651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6" name="Triangle isocèle 95"/>
            <p:cNvSpPr/>
            <p:nvPr/>
          </p:nvSpPr>
          <p:spPr>
            <a:xfrm flipV="1">
              <a:off x="6104932" y="5294443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7" name="Triangle isocèle 96"/>
            <p:cNvSpPr/>
            <p:nvPr/>
          </p:nvSpPr>
          <p:spPr>
            <a:xfrm>
              <a:off x="6312467" y="5317374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98" name="Triangle isocèle 97"/>
            <p:cNvSpPr/>
            <p:nvPr/>
          </p:nvSpPr>
          <p:spPr>
            <a:xfrm flipV="1">
              <a:off x="6446729" y="4908580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90086" y="3839043"/>
              <a:ext cx="2004713" cy="20901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9" name="Triangle isocèle 90"/>
            <p:cNvSpPr/>
            <p:nvPr/>
          </p:nvSpPr>
          <p:spPr>
            <a:xfrm flipV="1">
              <a:off x="5187110" y="4116739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0" name="Triangle isocèle 91"/>
            <p:cNvSpPr/>
            <p:nvPr/>
          </p:nvSpPr>
          <p:spPr>
            <a:xfrm>
              <a:off x="4842518" y="4165782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1" name="Triangle isocèle 92"/>
            <p:cNvSpPr/>
            <p:nvPr/>
          </p:nvSpPr>
          <p:spPr>
            <a:xfrm flipV="1">
              <a:off x="5313368" y="5251421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2" name="Triangle isocèle 93"/>
            <p:cNvSpPr/>
            <p:nvPr/>
          </p:nvSpPr>
          <p:spPr>
            <a:xfrm>
              <a:off x="5582448" y="5141232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3" name="Triangle isocèle 94"/>
            <p:cNvSpPr/>
            <p:nvPr/>
          </p:nvSpPr>
          <p:spPr>
            <a:xfrm flipV="1">
              <a:off x="5284297" y="560158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4" name="Triangle isocèle 95"/>
            <p:cNvSpPr/>
            <p:nvPr/>
          </p:nvSpPr>
          <p:spPr>
            <a:xfrm flipV="1">
              <a:off x="5992084" y="5470657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5" name="Triangle isocèle 96"/>
            <p:cNvSpPr/>
            <p:nvPr/>
          </p:nvSpPr>
          <p:spPr>
            <a:xfrm>
              <a:off x="6432864" y="5441748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6" name="Triangle isocèle 97"/>
            <p:cNvSpPr/>
            <p:nvPr/>
          </p:nvSpPr>
          <p:spPr>
            <a:xfrm flipV="1">
              <a:off x="6567126" y="5032954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188" name="Rectangle 187"/>
            <p:cNvSpPr/>
            <p:nvPr/>
          </p:nvSpPr>
          <p:spPr>
            <a:xfrm>
              <a:off x="4700930" y="3839043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  <a:latin typeface="Arial"/>
                <a:cs typeface="Arial"/>
              </a:endParaRPr>
            </a:p>
          </p:txBody>
        </p:sp>
        <p:sp>
          <p:nvSpPr>
            <p:cNvPr id="221" name="Triangle isocèle 90"/>
            <p:cNvSpPr/>
            <p:nvPr/>
          </p:nvSpPr>
          <p:spPr>
            <a:xfrm flipV="1">
              <a:off x="5520922" y="4074739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2" name="Triangle isocèle 91"/>
            <p:cNvSpPr/>
            <p:nvPr/>
          </p:nvSpPr>
          <p:spPr>
            <a:xfrm>
              <a:off x="5202246" y="4577382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3" name="Triangle isocèle 93"/>
            <p:cNvSpPr/>
            <p:nvPr/>
          </p:nvSpPr>
          <p:spPr>
            <a:xfrm>
              <a:off x="6188378" y="5572272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4" name="Triangle isocèle 95"/>
            <p:cNvSpPr/>
            <p:nvPr/>
          </p:nvSpPr>
          <p:spPr>
            <a:xfrm flipV="1">
              <a:off x="5528979" y="5493457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5" name="Triangle isocèle 95"/>
            <p:cNvSpPr/>
            <p:nvPr/>
          </p:nvSpPr>
          <p:spPr>
            <a:xfrm flipV="1">
              <a:off x="5616589" y="5775457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6" name="Triangle isocèle 94"/>
            <p:cNvSpPr/>
            <p:nvPr/>
          </p:nvSpPr>
          <p:spPr>
            <a:xfrm flipV="1">
              <a:off x="5047957" y="552718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7" name="Triangle isocèle 94"/>
            <p:cNvSpPr/>
            <p:nvPr/>
          </p:nvSpPr>
          <p:spPr>
            <a:xfrm flipV="1">
              <a:off x="4779222" y="552406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8" name="Triangle isocèle 94"/>
            <p:cNvSpPr/>
            <p:nvPr/>
          </p:nvSpPr>
          <p:spPr>
            <a:xfrm flipV="1">
              <a:off x="4931622" y="500254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29" name="Triangle isocèle 94"/>
            <p:cNvSpPr/>
            <p:nvPr/>
          </p:nvSpPr>
          <p:spPr>
            <a:xfrm>
              <a:off x="5880939" y="473374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30" name="Triangle isocèle 94"/>
            <p:cNvSpPr/>
            <p:nvPr/>
          </p:nvSpPr>
          <p:spPr>
            <a:xfrm flipV="1">
              <a:off x="6175877" y="470470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31" name="Triangle isocèle 94"/>
            <p:cNvSpPr/>
            <p:nvPr/>
          </p:nvSpPr>
          <p:spPr>
            <a:xfrm flipV="1">
              <a:off x="6159823" y="4079505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  <p:sp>
          <p:nvSpPr>
            <p:cNvPr id="240" name="Triangle isocèle 91"/>
            <p:cNvSpPr/>
            <p:nvPr/>
          </p:nvSpPr>
          <p:spPr>
            <a:xfrm>
              <a:off x="5056612" y="4755702"/>
              <a:ext cx="45778" cy="5949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/>
                <a:cs typeface="Arial"/>
              </a:endParaRPr>
            </a:p>
          </p:txBody>
        </p:sp>
      </p:grpSp>
      <p:grpSp>
        <p:nvGrpSpPr>
          <p:cNvPr id="194" name="Group 193"/>
          <p:cNvGrpSpPr/>
          <p:nvPr/>
        </p:nvGrpSpPr>
        <p:grpSpPr>
          <a:xfrm>
            <a:off x="6811879" y="3839043"/>
            <a:ext cx="2047929" cy="2086036"/>
            <a:chOff x="6780266" y="3839043"/>
            <a:chExt cx="2047929" cy="2086036"/>
          </a:xfrm>
        </p:grpSpPr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6780266" y="3839043"/>
              <a:ext cx="2047929" cy="20860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92" name="Straight Connector 191"/>
            <p:cNvCxnSpPr/>
            <p:nvPr/>
          </p:nvCxnSpPr>
          <p:spPr>
            <a:xfrm>
              <a:off x="8290577" y="5778236"/>
              <a:ext cx="48355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Rectangle 192"/>
            <p:cNvSpPr/>
            <p:nvPr/>
          </p:nvSpPr>
          <p:spPr>
            <a:xfrm>
              <a:off x="6780266" y="3839043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  <a:latin typeface="Arial"/>
                <a:cs typeface="Arial"/>
              </a:endParaRPr>
            </a:p>
          </p:txBody>
        </p:sp>
      </p:grpSp>
      <p:sp>
        <p:nvSpPr>
          <p:cNvPr id="2" name="Forme libre 1"/>
          <p:cNvSpPr/>
          <p:nvPr/>
        </p:nvSpPr>
        <p:spPr>
          <a:xfrm>
            <a:off x="6841033" y="3934463"/>
            <a:ext cx="1961799" cy="1934047"/>
          </a:xfrm>
          <a:custGeom>
            <a:avLst/>
            <a:gdLst>
              <a:gd name="connsiteX0" fmla="*/ 1248029 w 1961799"/>
              <a:gd name="connsiteY0" fmla="*/ 7074 h 1934047"/>
              <a:gd name="connsiteX1" fmla="*/ 1018129 w 1961799"/>
              <a:gd name="connsiteY1" fmla="*/ 39920 h 1934047"/>
              <a:gd name="connsiteX2" fmla="*/ 985286 w 1961799"/>
              <a:gd name="connsiteY2" fmla="*/ 61817 h 1934047"/>
              <a:gd name="connsiteX3" fmla="*/ 963391 w 1961799"/>
              <a:gd name="connsiteY3" fmla="*/ 83715 h 1934047"/>
              <a:gd name="connsiteX4" fmla="*/ 886757 w 1961799"/>
              <a:gd name="connsiteY4" fmla="*/ 149407 h 1934047"/>
              <a:gd name="connsiteX5" fmla="*/ 853914 w 1961799"/>
              <a:gd name="connsiteY5" fmla="*/ 182253 h 1934047"/>
              <a:gd name="connsiteX6" fmla="*/ 842967 w 1961799"/>
              <a:gd name="connsiteY6" fmla="*/ 215099 h 1934047"/>
              <a:gd name="connsiteX7" fmla="*/ 700648 w 1961799"/>
              <a:gd name="connsiteY7" fmla="*/ 313638 h 1934047"/>
              <a:gd name="connsiteX8" fmla="*/ 634962 w 1961799"/>
              <a:gd name="connsiteY8" fmla="*/ 368381 h 1934047"/>
              <a:gd name="connsiteX9" fmla="*/ 602119 w 1961799"/>
              <a:gd name="connsiteY9" fmla="*/ 379330 h 1934047"/>
              <a:gd name="connsiteX10" fmla="*/ 536433 w 1961799"/>
              <a:gd name="connsiteY10" fmla="*/ 434073 h 1934047"/>
              <a:gd name="connsiteX11" fmla="*/ 492643 w 1961799"/>
              <a:gd name="connsiteY11" fmla="*/ 521663 h 1934047"/>
              <a:gd name="connsiteX12" fmla="*/ 470748 w 1961799"/>
              <a:gd name="connsiteY12" fmla="*/ 554509 h 1934047"/>
              <a:gd name="connsiteX13" fmla="*/ 437905 w 1961799"/>
              <a:gd name="connsiteY13" fmla="*/ 565458 h 1934047"/>
              <a:gd name="connsiteX14" fmla="*/ 416010 w 1961799"/>
              <a:gd name="connsiteY14" fmla="*/ 631150 h 1934047"/>
              <a:gd name="connsiteX15" fmla="*/ 405062 w 1961799"/>
              <a:gd name="connsiteY15" fmla="*/ 674945 h 1934047"/>
              <a:gd name="connsiteX16" fmla="*/ 339376 w 1961799"/>
              <a:gd name="connsiteY16" fmla="*/ 718740 h 1934047"/>
              <a:gd name="connsiteX17" fmla="*/ 306533 w 1961799"/>
              <a:gd name="connsiteY17" fmla="*/ 751586 h 1934047"/>
              <a:gd name="connsiteX18" fmla="*/ 262743 w 1961799"/>
              <a:gd name="connsiteY18" fmla="*/ 828227 h 1934047"/>
              <a:gd name="connsiteX19" fmla="*/ 240848 w 1961799"/>
              <a:gd name="connsiteY19" fmla="*/ 861073 h 1934047"/>
              <a:gd name="connsiteX20" fmla="*/ 218952 w 1961799"/>
              <a:gd name="connsiteY20" fmla="*/ 937714 h 1934047"/>
              <a:gd name="connsiteX21" fmla="*/ 175162 w 1961799"/>
              <a:gd name="connsiteY21" fmla="*/ 1003406 h 1934047"/>
              <a:gd name="connsiteX22" fmla="*/ 153267 w 1961799"/>
              <a:gd name="connsiteY22" fmla="*/ 1036253 h 1934047"/>
              <a:gd name="connsiteX23" fmla="*/ 109476 w 1961799"/>
              <a:gd name="connsiteY23" fmla="*/ 1101945 h 1934047"/>
              <a:gd name="connsiteX24" fmla="*/ 87581 w 1961799"/>
              <a:gd name="connsiteY24" fmla="*/ 1167637 h 1934047"/>
              <a:gd name="connsiteX25" fmla="*/ 76633 w 1961799"/>
              <a:gd name="connsiteY25" fmla="*/ 1200483 h 1934047"/>
              <a:gd name="connsiteX26" fmla="*/ 54738 w 1961799"/>
              <a:gd name="connsiteY26" fmla="*/ 1309970 h 1934047"/>
              <a:gd name="connsiteX27" fmla="*/ 32843 w 1961799"/>
              <a:gd name="connsiteY27" fmla="*/ 1386611 h 1934047"/>
              <a:gd name="connsiteX28" fmla="*/ 0 w 1961799"/>
              <a:gd name="connsiteY28" fmla="*/ 1496099 h 1934047"/>
              <a:gd name="connsiteX29" fmla="*/ 21895 w 1961799"/>
              <a:gd name="connsiteY29" fmla="*/ 1682227 h 1934047"/>
              <a:gd name="connsiteX30" fmla="*/ 131371 w 1961799"/>
              <a:gd name="connsiteY30" fmla="*/ 1769816 h 1934047"/>
              <a:gd name="connsiteX31" fmla="*/ 175162 w 1961799"/>
              <a:gd name="connsiteY31" fmla="*/ 1802663 h 1934047"/>
              <a:gd name="connsiteX32" fmla="*/ 273690 w 1961799"/>
              <a:gd name="connsiteY32" fmla="*/ 1835509 h 1934047"/>
              <a:gd name="connsiteX33" fmla="*/ 339376 w 1961799"/>
              <a:gd name="connsiteY33" fmla="*/ 1857406 h 1934047"/>
              <a:gd name="connsiteX34" fmla="*/ 372219 w 1961799"/>
              <a:gd name="connsiteY34" fmla="*/ 1868355 h 1934047"/>
              <a:gd name="connsiteX35" fmla="*/ 711595 w 1961799"/>
              <a:gd name="connsiteY35" fmla="*/ 1912150 h 1934047"/>
              <a:gd name="connsiteX36" fmla="*/ 766333 w 1961799"/>
              <a:gd name="connsiteY36" fmla="*/ 1923098 h 1934047"/>
              <a:gd name="connsiteX37" fmla="*/ 810124 w 1961799"/>
              <a:gd name="connsiteY37" fmla="*/ 1934047 h 1934047"/>
              <a:gd name="connsiteX38" fmla="*/ 1105710 w 1961799"/>
              <a:gd name="connsiteY38" fmla="*/ 1923098 h 1934047"/>
              <a:gd name="connsiteX39" fmla="*/ 1138552 w 1961799"/>
              <a:gd name="connsiteY39" fmla="*/ 1901201 h 1934047"/>
              <a:gd name="connsiteX40" fmla="*/ 1204238 w 1961799"/>
              <a:gd name="connsiteY40" fmla="*/ 1879304 h 1934047"/>
              <a:gd name="connsiteX41" fmla="*/ 1357505 w 1961799"/>
              <a:gd name="connsiteY41" fmla="*/ 1857406 h 1934047"/>
              <a:gd name="connsiteX42" fmla="*/ 1390348 w 1961799"/>
              <a:gd name="connsiteY42" fmla="*/ 1846457 h 1934047"/>
              <a:gd name="connsiteX43" fmla="*/ 1434138 w 1961799"/>
              <a:gd name="connsiteY43" fmla="*/ 1835509 h 1934047"/>
              <a:gd name="connsiteX44" fmla="*/ 1466981 w 1961799"/>
              <a:gd name="connsiteY44" fmla="*/ 1813611 h 1934047"/>
              <a:gd name="connsiteX45" fmla="*/ 1510772 w 1961799"/>
              <a:gd name="connsiteY45" fmla="*/ 1791714 h 1934047"/>
              <a:gd name="connsiteX46" fmla="*/ 1554562 w 1961799"/>
              <a:gd name="connsiteY46" fmla="*/ 1726022 h 1934047"/>
              <a:gd name="connsiteX47" fmla="*/ 1576457 w 1961799"/>
              <a:gd name="connsiteY47" fmla="*/ 1693175 h 1934047"/>
              <a:gd name="connsiteX48" fmla="*/ 1664038 w 1961799"/>
              <a:gd name="connsiteY48" fmla="*/ 1594637 h 1934047"/>
              <a:gd name="connsiteX49" fmla="*/ 1751619 w 1961799"/>
              <a:gd name="connsiteY49" fmla="*/ 1550842 h 1934047"/>
              <a:gd name="connsiteX50" fmla="*/ 1861095 w 1961799"/>
              <a:gd name="connsiteY50" fmla="*/ 1485150 h 1934047"/>
              <a:gd name="connsiteX51" fmla="*/ 1882991 w 1961799"/>
              <a:gd name="connsiteY51" fmla="*/ 1463252 h 1934047"/>
              <a:gd name="connsiteX52" fmla="*/ 1893938 w 1961799"/>
              <a:gd name="connsiteY52" fmla="*/ 1419458 h 1934047"/>
              <a:gd name="connsiteX53" fmla="*/ 1915834 w 1961799"/>
              <a:gd name="connsiteY53" fmla="*/ 1386611 h 1934047"/>
              <a:gd name="connsiteX54" fmla="*/ 1926781 w 1961799"/>
              <a:gd name="connsiteY54" fmla="*/ 1331868 h 1934047"/>
              <a:gd name="connsiteX55" fmla="*/ 1948676 w 1961799"/>
              <a:gd name="connsiteY55" fmla="*/ 1266176 h 1934047"/>
              <a:gd name="connsiteX56" fmla="*/ 1926781 w 1961799"/>
              <a:gd name="connsiteY56" fmla="*/ 1090996 h 1934047"/>
              <a:gd name="connsiteX57" fmla="*/ 1904886 w 1961799"/>
              <a:gd name="connsiteY57" fmla="*/ 1058150 h 1934047"/>
              <a:gd name="connsiteX58" fmla="*/ 1872043 w 1961799"/>
              <a:gd name="connsiteY58" fmla="*/ 948663 h 1934047"/>
              <a:gd name="connsiteX59" fmla="*/ 1861095 w 1961799"/>
              <a:gd name="connsiteY59" fmla="*/ 904868 h 1934047"/>
              <a:gd name="connsiteX60" fmla="*/ 1872043 w 1961799"/>
              <a:gd name="connsiteY60" fmla="*/ 850125 h 1934047"/>
              <a:gd name="connsiteX61" fmla="*/ 1937729 w 1961799"/>
              <a:gd name="connsiteY61" fmla="*/ 795381 h 1934047"/>
              <a:gd name="connsiteX62" fmla="*/ 1926781 w 1961799"/>
              <a:gd name="connsiteY62" fmla="*/ 368381 h 1934047"/>
              <a:gd name="connsiteX63" fmla="*/ 1904886 w 1961799"/>
              <a:gd name="connsiteY63" fmla="*/ 335535 h 1934047"/>
              <a:gd name="connsiteX64" fmla="*/ 1872043 w 1961799"/>
              <a:gd name="connsiteY64" fmla="*/ 291740 h 1934047"/>
              <a:gd name="connsiteX65" fmla="*/ 1828253 w 1961799"/>
              <a:gd name="connsiteY65" fmla="*/ 226048 h 1934047"/>
              <a:gd name="connsiteX66" fmla="*/ 1751619 w 1961799"/>
              <a:gd name="connsiteY66" fmla="*/ 171304 h 1934047"/>
              <a:gd name="connsiteX67" fmla="*/ 1674986 w 1961799"/>
              <a:gd name="connsiteY67" fmla="*/ 138458 h 1934047"/>
              <a:gd name="connsiteX68" fmla="*/ 1609300 w 1961799"/>
              <a:gd name="connsiteY68" fmla="*/ 116561 h 1934047"/>
              <a:gd name="connsiteX69" fmla="*/ 1510772 w 1961799"/>
              <a:gd name="connsiteY69" fmla="*/ 94663 h 1934047"/>
              <a:gd name="connsiteX70" fmla="*/ 1445086 w 1961799"/>
              <a:gd name="connsiteY70" fmla="*/ 72766 h 1934047"/>
              <a:gd name="connsiteX71" fmla="*/ 1401295 w 1961799"/>
              <a:gd name="connsiteY71" fmla="*/ 50868 h 1934047"/>
              <a:gd name="connsiteX72" fmla="*/ 1335610 w 1961799"/>
              <a:gd name="connsiteY72" fmla="*/ 28971 h 1934047"/>
              <a:gd name="connsiteX73" fmla="*/ 1313714 w 1961799"/>
              <a:gd name="connsiteY73" fmla="*/ 7074 h 1934047"/>
              <a:gd name="connsiteX74" fmla="*/ 1248029 w 1961799"/>
              <a:gd name="connsiteY74" fmla="*/ 7074 h 1934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</a:cxnLst>
            <a:rect l="l" t="t" r="r" b="b"/>
            <a:pathLst>
              <a:path w="1961799" h="1934047">
                <a:moveTo>
                  <a:pt x="1248029" y="7074"/>
                </a:moveTo>
                <a:cubicBezTo>
                  <a:pt x="1198765" y="12548"/>
                  <a:pt x="1070457" y="5032"/>
                  <a:pt x="1018129" y="39920"/>
                </a:cubicBezTo>
                <a:cubicBezTo>
                  <a:pt x="1007181" y="47219"/>
                  <a:pt x="995560" y="53597"/>
                  <a:pt x="985286" y="61817"/>
                </a:cubicBezTo>
                <a:cubicBezTo>
                  <a:pt x="977226" y="68266"/>
                  <a:pt x="971451" y="77266"/>
                  <a:pt x="963391" y="83715"/>
                </a:cubicBezTo>
                <a:cubicBezTo>
                  <a:pt x="880018" y="150421"/>
                  <a:pt x="992182" y="43972"/>
                  <a:pt x="886757" y="149407"/>
                </a:cubicBezTo>
                <a:lnTo>
                  <a:pt x="853914" y="182253"/>
                </a:lnTo>
                <a:cubicBezTo>
                  <a:pt x="850265" y="193202"/>
                  <a:pt x="851127" y="206938"/>
                  <a:pt x="842967" y="215099"/>
                </a:cubicBezTo>
                <a:cubicBezTo>
                  <a:pt x="754911" y="303163"/>
                  <a:pt x="772493" y="272579"/>
                  <a:pt x="700648" y="313638"/>
                </a:cubicBezTo>
                <a:cubicBezTo>
                  <a:pt x="575278" y="385286"/>
                  <a:pt x="770828" y="277795"/>
                  <a:pt x="634962" y="368381"/>
                </a:cubicBezTo>
                <a:cubicBezTo>
                  <a:pt x="625360" y="374783"/>
                  <a:pt x="612440" y="374169"/>
                  <a:pt x="602119" y="379330"/>
                </a:cubicBezTo>
                <a:cubicBezTo>
                  <a:pt x="571634" y="394574"/>
                  <a:pt x="560645" y="409859"/>
                  <a:pt x="536433" y="434073"/>
                </a:cubicBezTo>
                <a:cubicBezTo>
                  <a:pt x="521836" y="463270"/>
                  <a:pt x="510748" y="494502"/>
                  <a:pt x="492643" y="521663"/>
                </a:cubicBezTo>
                <a:cubicBezTo>
                  <a:pt x="485345" y="532612"/>
                  <a:pt x="481022" y="546289"/>
                  <a:pt x="470748" y="554509"/>
                </a:cubicBezTo>
                <a:cubicBezTo>
                  <a:pt x="461737" y="561718"/>
                  <a:pt x="448853" y="561808"/>
                  <a:pt x="437905" y="565458"/>
                </a:cubicBezTo>
                <a:cubicBezTo>
                  <a:pt x="430607" y="587355"/>
                  <a:pt x="421608" y="608757"/>
                  <a:pt x="416010" y="631150"/>
                </a:cubicBezTo>
                <a:cubicBezTo>
                  <a:pt x="412361" y="645748"/>
                  <a:pt x="414970" y="663620"/>
                  <a:pt x="405062" y="674945"/>
                </a:cubicBezTo>
                <a:cubicBezTo>
                  <a:pt x="387734" y="694750"/>
                  <a:pt x="357983" y="700131"/>
                  <a:pt x="339376" y="718740"/>
                </a:cubicBezTo>
                <a:cubicBezTo>
                  <a:pt x="328428" y="729689"/>
                  <a:pt x="316444" y="739691"/>
                  <a:pt x="306533" y="751586"/>
                </a:cubicBezTo>
                <a:cubicBezTo>
                  <a:pt x="282286" y="780685"/>
                  <a:pt x="282211" y="794155"/>
                  <a:pt x="262743" y="828227"/>
                </a:cubicBezTo>
                <a:cubicBezTo>
                  <a:pt x="256215" y="839652"/>
                  <a:pt x="248146" y="850124"/>
                  <a:pt x="240848" y="861073"/>
                </a:cubicBezTo>
                <a:cubicBezTo>
                  <a:pt x="238271" y="871382"/>
                  <a:pt x="226092" y="924862"/>
                  <a:pt x="218952" y="937714"/>
                </a:cubicBezTo>
                <a:cubicBezTo>
                  <a:pt x="206173" y="960719"/>
                  <a:pt x="189759" y="981509"/>
                  <a:pt x="175162" y="1003406"/>
                </a:cubicBezTo>
                <a:cubicBezTo>
                  <a:pt x="167864" y="1014355"/>
                  <a:pt x="157428" y="1023770"/>
                  <a:pt x="153267" y="1036253"/>
                </a:cubicBezTo>
                <a:cubicBezTo>
                  <a:pt x="137423" y="1083788"/>
                  <a:pt x="150479" y="1060938"/>
                  <a:pt x="109476" y="1101945"/>
                </a:cubicBezTo>
                <a:lnTo>
                  <a:pt x="87581" y="1167637"/>
                </a:lnTo>
                <a:cubicBezTo>
                  <a:pt x="83932" y="1178586"/>
                  <a:pt x="78896" y="1189166"/>
                  <a:pt x="76633" y="1200483"/>
                </a:cubicBezTo>
                <a:cubicBezTo>
                  <a:pt x="69335" y="1236979"/>
                  <a:pt x="63764" y="1273863"/>
                  <a:pt x="54738" y="1309970"/>
                </a:cubicBezTo>
                <a:cubicBezTo>
                  <a:pt x="20512" y="1446882"/>
                  <a:pt x="64254" y="1276660"/>
                  <a:pt x="32843" y="1386611"/>
                </a:cubicBezTo>
                <a:cubicBezTo>
                  <a:pt x="-244" y="1502429"/>
                  <a:pt x="52026" y="1340002"/>
                  <a:pt x="0" y="1496099"/>
                </a:cubicBezTo>
                <a:cubicBezTo>
                  <a:pt x="7298" y="1558142"/>
                  <a:pt x="1374" y="1623223"/>
                  <a:pt x="21895" y="1682227"/>
                </a:cubicBezTo>
                <a:cubicBezTo>
                  <a:pt x="42302" y="1740902"/>
                  <a:pt x="89829" y="1743850"/>
                  <a:pt x="131371" y="1769816"/>
                </a:cubicBezTo>
                <a:cubicBezTo>
                  <a:pt x="146844" y="1779488"/>
                  <a:pt x="159212" y="1793801"/>
                  <a:pt x="175162" y="1802663"/>
                </a:cubicBezTo>
                <a:cubicBezTo>
                  <a:pt x="218104" y="1826522"/>
                  <a:pt x="230562" y="1822569"/>
                  <a:pt x="273690" y="1835509"/>
                </a:cubicBezTo>
                <a:cubicBezTo>
                  <a:pt x="295796" y="1842142"/>
                  <a:pt x="317481" y="1850107"/>
                  <a:pt x="339376" y="1857406"/>
                </a:cubicBezTo>
                <a:cubicBezTo>
                  <a:pt x="350324" y="1861056"/>
                  <a:pt x="360820" y="1866555"/>
                  <a:pt x="372219" y="1868355"/>
                </a:cubicBezTo>
                <a:cubicBezTo>
                  <a:pt x="623628" y="1908055"/>
                  <a:pt x="510272" y="1895371"/>
                  <a:pt x="711595" y="1912150"/>
                </a:cubicBezTo>
                <a:cubicBezTo>
                  <a:pt x="729841" y="1915799"/>
                  <a:pt x="748169" y="1919061"/>
                  <a:pt x="766333" y="1923098"/>
                </a:cubicBezTo>
                <a:cubicBezTo>
                  <a:pt x="781021" y="1926362"/>
                  <a:pt x="795078" y="1934047"/>
                  <a:pt x="810124" y="1934047"/>
                </a:cubicBezTo>
                <a:cubicBezTo>
                  <a:pt x="908720" y="1934047"/>
                  <a:pt x="1007181" y="1926748"/>
                  <a:pt x="1105710" y="1923098"/>
                </a:cubicBezTo>
                <a:cubicBezTo>
                  <a:pt x="1116657" y="1915799"/>
                  <a:pt x="1126529" y="1906545"/>
                  <a:pt x="1138552" y="1901201"/>
                </a:cubicBezTo>
                <a:cubicBezTo>
                  <a:pt x="1159642" y="1891827"/>
                  <a:pt x="1182343" y="1886603"/>
                  <a:pt x="1204238" y="1879304"/>
                </a:cubicBezTo>
                <a:cubicBezTo>
                  <a:pt x="1275322" y="1855607"/>
                  <a:pt x="1225578" y="1869401"/>
                  <a:pt x="1357505" y="1857406"/>
                </a:cubicBezTo>
                <a:cubicBezTo>
                  <a:pt x="1368453" y="1853756"/>
                  <a:pt x="1379252" y="1849628"/>
                  <a:pt x="1390348" y="1846457"/>
                </a:cubicBezTo>
                <a:cubicBezTo>
                  <a:pt x="1404815" y="1842323"/>
                  <a:pt x="1420309" y="1841436"/>
                  <a:pt x="1434138" y="1835509"/>
                </a:cubicBezTo>
                <a:cubicBezTo>
                  <a:pt x="1446232" y="1830325"/>
                  <a:pt x="1455557" y="1820140"/>
                  <a:pt x="1466981" y="1813611"/>
                </a:cubicBezTo>
                <a:cubicBezTo>
                  <a:pt x="1481151" y="1805513"/>
                  <a:pt x="1496175" y="1799013"/>
                  <a:pt x="1510772" y="1791714"/>
                </a:cubicBezTo>
                <a:lnTo>
                  <a:pt x="1554562" y="1726022"/>
                </a:lnTo>
                <a:lnTo>
                  <a:pt x="1576457" y="1693175"/>
                </a:lnTo>
                <a:cubicBezTo>
                  <a:pt x="1599594" y="1658466"/>
                  <a:pt x="1626549" y="1613383"/>
                  <a:pt x="1664038" y="1594637"/>
                </a:cubicBezTo>
                <a:lnTo>
                  <a:pt x="1751619" y="1550842"/>
                </a:lnTo>
                <a:cubicBezTo>
                  <a:pt x="1786178" y="1533561"/>
                  <a:pt x="1834669" y="1511579"/>
                  <a:pt x="1861095" y="1485150"/>
                </a:cubicBezTo>
                <a:lnTo>
                  <a:pt x="1882991" y="1463252"/>
                </a:lnTo>
                <a:cubicBezTo>
                  <a:pt x="1886640" y="1448654"/>
                  <a:pt x="1888011" y="1433289"/>
                  <a:pt x="1893938" y="1419458"/>
                </a:cubicBezTo>
                <a:cubicBezTo>
                  <a:pt x="1899121" y="1407363"/>
                  <a:pt x="1911214" y="1398932"/>
                  <a:pt x="1915834" y="1386611"/>
                </a:cubicBezTo>
                <a:cubicBezTo>
                  <a:pt x="1922367" y="1369187"/>
                  <a:pt x="1921885" y="1349821"/>
                  <a:pt x="1926781" y="1331868"/>
                </a:cubicBezTo>
                <a:cubicBezTo>
                  <a:pt x="1932853" y="1309600"/>
                  <a:pt x="1941378" y="1288073"/>
                  <a:pt x="1948676" y="1266176"/>
                </a:cubicBezTo>
                <a:cubicBezTo>
                  <a:pt x="1941378" y="1207783"/>
                  <a:pt x="1938903" y="1148582"/>
                  <a:pt x="1926781" y="1090996"/>
                </a:cubicBezTo>
                <a:cubicBezTo>
                  <a:pt x="1924071" y="1078120"/>
                  <a:pt x="1908667" y="1070753"/>
                  <a:pt x="1904886" y="1058150"/>
                </a:cubicBezTo>
                <a:cubicBezTo>
                  <a:pt x="1866461" y="930054"/>
                  <a:pt x="1921313" y="1022576"/>
                  <a:pt x="1872043" y="948663"/>
                </a:cubicBezTo>
                <a:cubicBezTo>
                  <a:pt x="1868394" y="934065"/>
                  <a:pt x="1861095" y="919916"/>
                  <a:pt x="1861095" y="904868"/>
                </a:cubicBezTo>
                <a:cubicBezTo>
                  <a:pt x="1861095" y="886259"/>
                  <a:pt x="1863721" y="866770"/>
                  <a:pt x="1872043" y="850125"/>
                </a:cubicBezTo>
                <a:cubicBezTo>
                  <a:pt x="1882581" y="829047"/>
                  <a:pt x="1918865" y="807958"/>
                  <a:pt x="1937729" y="795381"/>
                </a:cubicBezTo>
                <a:cubicBezTo>
                  <a:pt x="1978116" y="633806"/>
                  <a:pt x="1963018" y="712667"/>
                  <a:pt x="1926781" y="368381"/>
                </a:cubicBezTo>
                <a:cubicBezTo>
                  <a:pt x="1925404" y="355295"/>
                  <a:pt x="1912534" y="346243"/>
                  <a:pt x="1904886" y="335535"/>
                </a:cubicBezTo>
                <a:cubicBezTo>
                  <a:pt x="1894281" y="320686"/>
                  <a:pt x="1882506" y="306689"/>
                  <a:pt x="1872043" y="291740"/>
                </a:cubicBezTo>
                <a:cubicBezTo>
                  <a:pt x="1856953" y="270180"/>
                  <a:pt x="1851791" y="237818"/>
                  <a:pt x="1828253" y="226048"/>
                </a:cubicBezTo>
                <a:cubicBezTo>
                  <a:pt x="1747221" y="185527"/>
                  <a:pt x="1818195" y="226789"/>
                  <a:pt x="1751619" y="171304"/>
                </a:cubicBezTo>
                <a:cubicBezTo>
                  <a:pt x="1715798" y="141450"/>
                  <a:pt x="1720631" y="152153"/>
                  <a:pt x="1674986" y="138458"/>
                </a:cubicBezTo>
                <a:cubicBezTo>
                  <a:pt x="1652880" y="131825"/>
                  <a:pt x="1631932" y="121088"/>
                  <a:pt x="1609300" y="116561"/>
                </a:cubicBezTo>
                <a:cubicBezTo>
                  <a:pt x="1578043" y="110309"/>
                  <a:pt x="1541697" y="103941"/>
                  <a:pt x="1510772" y="94663"/>
                </a:cubicBezTo>
                <a:cubicBezTo>
                  <a:pt x="1488666" y="88030"/>
                  <a:pt x="1465729" y="83089"/>
                  <a:pt x="1445086" y="72766"/>
                </a:cubicBezTo>
                <a:cubicBezTo>
                  <a:pt x="1430489" y="65467"/>
                  <a:pt x="1416448" y="56930"/>
                  <a:pt x="1401295" y="50868"/>
                </a:cubicBezTo>
                <a:cubicBezTo>
                  <a:pt x="1379866" y="42296"/>
                  <a:pt x="1335610" y="28971"/>
                  <a:pt x="1335610" y="28971"/>
                </a:cubicBezTo>
                <a:cubicBezTo>
                  <a:pt x="1328311" y="21672"/>
                  <a:pt x="1322946" y="11691"/>
                  <a:pt x="1313714" y="7074"/>
                </a:cubicBezTo>
                <a:cubicBezTo>
                  <a:pt x="1288278" y="-5645"/>
                  <a:pt x="1297293" y="1600"/>
                  <a:pt x="1248029" y="7074"/>
                </a:cubicBezTo>
                <a:close/>
              </a:path>
            </a:pathLst>
          </a:custGeom>
          <a:noFill/>
          <a:ln>
            <a:solidFill>
              <a:schemeClr val="bg1"/>
            </a:solidFill>
            <a:prstDash val="dash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sp>
        <p:nvSpPr>
          <p:cNvPr id="241" name="ZoneTexte 240"/>
          <p:cNvSpPr txBox="1"/>
          <p:nvPr/>
        </p:nvSpPr>
        <p:spPr>
          <a:xfrm>
            <a:off x="6825966" y="3843651"/>
            <a:ext cx="7360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solidFill>
                  <a:schemeClr val="bg1"/>
                </a:solidFill>
                <a:latin typeface="Arial"/>
                <a:cs typeface="Arial"/>
              </a:rPr>
              <a:t>Liver</a:t>
            </a:r>
            <a:r>
              <a:rPr lang="fr-FR" sz="800" dirty="0" smtClean="0">
                <a:solidFill>
                  <a:schemeClr val="bg1"/>
                </a:solidFill>
                <a:latin typeface="Arial"/>
                <a:cs typeface="Arial"/>
              </a:rPr>
              <a:t> Tissue</a:t>
            </a:r>
            <a:endParaRPr lang="fr-FR" sz="8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42" name="ZoneTexte 241"/>
          <p:cNvSpPr txBox="1"/>
          <p:nvPr/>
        </p:nvSpPr>
        <p:spPr>
          <a:xfrm>
            <a:off x="7572608" y="4924563"/>
            <a:ext cx="486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solidFill>
                  <a:schemeClr val="bg1"/>
                </a:solidFill>
                <a:latin typeface="Arial"/>
                <a:cs typeface="Arial"/>
              </a:rPr>
              <a:t>Lesion</a:t>
            </a:r>
            <a:endParaRPr lang="fr-FR" sz="8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67" name="ZoneTexte 47"/>
          <p:cNvSpPr txBox="1"/>
          <p:nvPr/>
        </p:nvSpPr>
        <p:spPr>
          <a:xfrm>
            <a:off x="5389354" y="6474356"/>
            <a:ext cx="3703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 smtClean="0">
                <a:latin typeface="Arial"/>
                <a:cs typeface="Arial"/>
              </a:rPr>
              <a:t>Tabariès</a:t>
            </a:r>
            <a:r>
              <a:rPr lang="fr-FR" sz="1600" dirty="0" smtClean="0">
                <a:latin typeface="Arial"/>
                <a:cs typeface="Arial"/>
              </a:rPr>
              <a:t> </a:t>
            </a:r>
            <a:r>
              <a:rPr lang="fr-FR" sz="1600" i="1" dirty="0" smtClean="0">
                <a:latin typeface="Arial"/>
                <a:cs typeface="Arial"/>
              </a:rPr>
              <a:t>et al</a:t>
            </a:r>
            <a:r>
              <a:rPr lang="fr-FR" sz="1600" dirty="0" smtClean="0">
                <a:latin typeface="Arial"/>
                <a:cs typeface="Arial"/>
              </a:rPr>
              <a:t>., 2015 – </a:t>
            </a:r>
            <a:r>
              <a:rPr lang="fr-FR" sz="1600" dirty="0" err="1" smtClean="0">
                <a:latin typeface="Arial"/>
                <a:cs typeface="Arial"/>
              </a:rPr>
              <a:t>Additional</a:t>
            </a:r>
            <a:r>
              <a:rPr lang="fr-FR" sz="1600" dirty="0" smtClean="0">
                <a:latin typeface="Arial"/>
                <a:cs typeface="Arial"/>
              </a:rPr>
              <a:t> File </a:t>
            </a:r>
            <a:r>
              <a:rPr lang="fr-FR" sz="1600" dirty="0">
                <a:latin typeface="Arial"/>
                <a:cs typeface="Arial"/>
              </a:rPr>
              <a:t>4</a:t>
            </a:r>
          </a:p>
        </p:txBody>
      </p:sp>
      <p:sp>
        <p:nvSpPr>
          <p:cNvPr id="171" name="ZoneTexte 6"/>
          <p:cNvSpPr txBox="1"/>
          <p:nvPr/>
        </p:nvSpPr>
        <p:spPr>
          <a:xfrm rot="16200000">
            <a:off x="-56013" y="156762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Distal</a:t>
            </a:r>
            <a:endParaRPr lang="fr-FR" sz="1200" dirty="0">
              <a:latin typeface="Arial"/>
              <a:cs typeface="Arial"/>
            </a:endParaRPr>
          </a:p>
        </p:txBody>
      </p:sp>
      <p:cxnSp>
        <p:nvCxnSpPr>
          <p:cNvPr id="187" name="Connecteur droit 39"/>
          <p:cNvCxnSpPr/>
          <p:nvPr/>
        </p:nvCxnSpPr>
        <p:spPr>
          <a:xfrm flipV="1">
            <a:off x="321655" y="765143"/>
            <a:ext cx="0" cy="198149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0" name="ZoneTexte 7"/>
          <p:cNvSpPr txBox="1"/>
          <p:nvPr/>
        </p:nvSpPr>
        <p:spPr>
          <a:xfrm rot="16200000">
            <a:off x="-368598" y="4820163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Invasive  Front</a:t>
            </a:r>
            <a:endParaRPr lang="fr-FR" sz="1200" dirty="0">
              <a:latin typeface="Arial"/>
              <a:cs typeface="Arial"/>
            </a:endParaRPr>
          </a:p>
        </p:txBody>
      </p:sp>
      <p:cxnSp>
        <p:nvCxnSpPr>
          <p:cNvPr id="203" name="Connecteur droit 39"/>
          <p:cNvCxnSpPr/>
          <p:nvPr/>
        </p:nvCxnSpPr>
        <p:spPr>
          <a:xfrm flipV="1">
            <a:off x="321655" y="3906023"/>
            <a:ext cx="0" cy="198149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" name="Grouper 7"/>
          <p:cNvGrpSpPr/>
          <p:nvPr/>
        </p:nvGrpSpPr>
        <p:grpSpPr>
          <a:xfrm>
            <a:off x="6855438" y="385810"/>
            <a:ext cx="2004370" cy="2397936"/>
            <a:chOff x="6855438" y="385810"/>
            <a:chExt cx="2004370" cy="2397936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6855438" y="695936"/>
              <a:ext cx="2004370" cy="20878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0" name="Rectangle 129"/>
            <p:cNvSpPr/>
            <p:nvPr/>
          </p:nvSpPr>
          <p:spPr>
            <a:xfrm>
              <a:off x="6865994" y="695643"/>
              <a:ext cx="1912330" cy="201002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  <a:latin typeface="Arial"/>
                <a:cs typeface="Arial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7495151" y="385810"/>
              <a:ext cx="72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70C0"/>
                  </a:solidFill>
                  <a:latin typeface="Arial"/>
                  <a:cs typeface="Arial"/>
                </a:rPr>
                <a:t>DAPI</a:t>
              </a:r>
              <a:endParaRPr lang="en-US" dirty="0">
                <a:solidFill>
                  <a:srgbClr val="0070C0"/>
                </a:solidFill>
                <a:latin typeface="Arial"/>
                <a:cs typeface="Arial"/>
              </a:endParaRPr>
            </a:p>
          </p:txBody>
        </p:sp>
        <p:sp>
          <p:nvSpPr>
            <p:cNvPr id="204" name="ZoneTexte 203"/>
            <p:cNvSpPr txBox="1"/>
            <p:nvPr/>
          </p:nvSpPr>
          <p:spPr>
            <a:xfrm>
              <a:off x="6948196" y="698324"/>
              <a:ext cx="10182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solidFill>
                    <a:schemeClr val="bg1"/>
                  </a:solidFill>
                  <a:latin typeface="Arial"/>
                  <a:cs typeface="Arial"/>
                </a:rPr>
                <a:t>Distal </a:t>
              </a:r>
              <a:r>
                <a:rPr lang="fr-FR" sz="800" dirty="0" err="1" smtClean="0">
                  <a:solidFill>
                    <a:schemeClr val="bg1"/>
                  </a:solidFill>
                  <a:latin typeface="Arial"/>
                  <a:cs typeface="Arial"/>
                </a:rPr>
                <a:t>Liver</a:t>
              </a:r>
              <a:r>
                <a:rPr lang="fr-FR" sz="800" dirty="0" smtClean="0">
                  <a:solidFill>
                    <a:schemeClr val="bg1"/>
                  </a:solidFill>
                  <a:latin typeface="Arial"/>
                  <a:cs typeface="Arial"/>
                </a:rPr>
                <a:t> Tissue</a:t>
              </a:r>
              <a:endParaRPr lang="fr-FR" sz="8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sp>
        <p:nvSpPr>
          <p:cNvPr id="175" name="Forme libre 174"/>
          <p:cNvSpPr/>
          <p:nvPr/>
        </p:nvSpPr>
        <p:spPr>
          <a:xfrm>
            <a:off x="4681738" y="3934463"/>
            <a:ext cx="1961799" cy="1934047"/>
          </a:xfrm>
          <a:custGeom>
            <a:avLst/>
            <a:gdLst>
              <a:gd name="connsiteX0" fmla="*/ 1248029 w 1961799"/>
              <a:gd name="connsiteY0" fmla="*/ 7074 h 1934047"/>
              <a:gd name="connsiteX1" fmla="*/ 1018129 w 1961799"/>
              <a:gd name="connsiteY1" fmla="*/ 39920 h 1934047"/>
              <a:gd name="connsiteX2" fmla="*/ 985286 w 1961799"/>
              <a:gd name="connsiteY2" fmla="*/ 61817 h 1934047"/>
              <a:gd name="connsiteX3" fmla="*/ 963391 w 1961799"/>
              <a:gd name="connsiteY3" fmla="*/ 83715 h 1934047"/>
              <a:gd name="connsiteX4" fmla="*/ 886757 w 1961799"/>
              <a:gd name="connsiteY4" fmla="*/ 149407 h 1934047"/>
              <a:gd name="connsiteX5" fmla="*/ 853914 w 1961799"/>
              <a:gd name="connsiteY5" fmla="*/ 182253 h 1934047"/>
              <a:gd name="connsiteX6" fmla="*/ 842967 w 1961799"/>
              <a:gd name="connsiteY6" fmla="*/ 215099 h 1934047"/>
              <a:gd name="connsiteX7" fmla="*/ 700648 w 1961799"/>
              <a:gd name="connsiteY7" fmla="*/ 313638 h 1934047"/>
              <a:gd name="connsiteX8" fmla="*/ 634962 w 1961799"/>
              <a:gd name="connsiteY8" fmla="*/ 368381 h 1934047"/>
              <a:gd name="connsiteX9" fmla="*/ 602119 w 1961799"/>
              <a:gd name="connsiteY9" fmla="*/ 379330 h 1934047"/>
              <a:gd name="connsiteX10" fmla="*/ 536433 w 1961799"/>
              <a:gd name="connsiteY10" fmla="*/ 434073 h 1934047"/>
              <a:gd name="connsiteX11" fmla="*/ 492643 w 1961799"/>
              <a:gd name="connsiteY11" fmla="*/ 521663 h 1934047"/>
              <a:gd name="connsiteX12" fmla="*/ 470748 w 1961799"/>
              <a:gd name="connsiteY12" fmla="*/ 554509 h 1934047"/>
              <a:gd name="connsiteX13" fmla="*/ 437905 w 1961799"/>
              <a:gd name="connsiteY13" fmla="*/ 565458 h 1934047"/>
              <a:gd name="connsiteX14" fmla="*/ 416010 w 1961799"/>
              <a:gd name="connsiteY14" fmla="*/ 631150 h 1934047"/>
              <a:gd name="connsiteX15" fmla="*/ 405062 w 1961799"/>
              <a:gd name="connsiteY15" fmla="*/ 674945 h 1934047"/>
              <a:gd name="connsiteX16" fmla="*/ 339376 w 1961799"/>
              <a:gd name="connsiteY16" fmla="*/ 718740 h 1934047"/>
              <a:gd name="connsiteX17" fmla="*/ 306533 w 1961799"/>
              <a:gd name="connsiteY17" fmla="*/ 751586 h 1934047"/>
              <a:gd name="connsiteX18" fmla="*/ 262743 w 1961799"/>
              <a:gd name="connsiteY18" fmla="*/ 828227 h 1934047"/>
              <a:gd name="connsiteX19" fmla="*/ 240848 w 1961799"/>
              <a:gd name="connsiteY19" fmla="*/ 861073 h 1934047"/>
              <a:gd name="connsiteX20" fmla="*/ 218952 w 1961799"/>
              <a:gd name="connsiteY20" fmla="*/ 937714 h 1934047"/>
              <a:gd name="connsiteX21" fmla="*/ 175162 w 1961799"/>
              <a:gd name="connsiteY21" fmla="*/ 1003406 h 1934047"/>
              <a:gd name="connsiteX22" fmla="*/ 153267 w 1961799"/>
              <a:gd name="connsiteY22" fmla="*/ 1036253 h 1934047"/>
              <a:gd name="connsiteX23" fmla="*/ 109476 w 1961799"/>
              <a:gd name="connsiteY23" fmla="*/ 1101945 h 1934047"/>
              <a:gd name="connsiteX24" fmla="*/ 87581 w 1961799"/>
              <a:gd name="connsiteY24" fmla="*/ 1167637 h 1934047"/>
              <a:gd name="connsiteX25" fmla="*/ 76633 w 1961799"/>
              <a:gd name="connsiteY25" fmla="*/ 1200483 h 1934047"/>
              <a:gd name="connsiteX26" fmla="*/ 54738 w 1961799"/>
              <a:gd name="connsiteY26" fmla="*/ 1309970 h 1934047"/>
              <a:gd name="connsiteX27" fmla="*/ 32843 w 1961799"/>
              <a:gd name="connsiteY27" fmla="*/ 1386611 h 1934047"/>
              <a:gd name="connsiteX28" fmla="*/ 0 w 1961799"/>
              <a:gd name="connsiteY28" fmla="*/ 1496099 h 1934047"/>
              <a:gd name="connsiteX29" fmla="*/ 21895 w 1961799"/>
              <a:gd name="connsiteY29" fmla="*/ 1682227 h 1934047"/>
              <a:gd name="connsiteX30" fmla="*/ 131371 w 1961799"/>
              <a:gd name="connsiteY30" fmla="*/ 1769816 h 1934047"/>
              <a:gd name="connsiteX31" fmla="*/ 175162 w 1961799"/>
              <a:gd name="connsiteY31" fmla="*/ 1802663 h 1934047"/>
              <a:gd name="connsiteX32" fmla="*/ 273690 w 1961799"/>
              <a:gd name="connsiteY32" fmla="*/ 1835509 h 1934047"/>
              <a:gd name="connsiteX33" fmla="*/ 339376 w 1961799"/>
              <a:gd name="connsiteY33" fmla="*/ 1857406 h 1934047"/>
              <a:gd name="connsiteX34" fmla="*/ 372219 w 1961799"/>
              <a:gd name="connsiteY34" fmla="*/ 1868355 h 1934047"/>
              <a:gd name="connsiteX35" fmla="*/ 711595 w 1961799"/>
              <a:gd name="connsiteY35" fmla="*/ 1912150 h 1934047"/>
              <a:gd name="connsiteX36" fmla="*/ 766333 w 1961799"/>
              <a:gd name="connsiteY36" fmla="*/ 1923098 h 1934047"/>
              <a:gd name="connsiteX37" fmla="*/ 810124 w 1961799"/>
              <a:gd name="connsiteY37" fmla="*/ 1934047 h 1934047"/>
              <a:gd name="connsiteX38" fmla="*/ 1105710 w 1961799"/>
              <a:gd name="connsiteY38" fmla="*/ 1923098 h 1934047"/>
              <a:gd name="connsiteX39" fmla="*/ 1138552 w 1961799"/>
              <a:gd name="connsiteY39" fmla="*/ 1901201 h 1934047"/>
              <a:gd name="connsiteX40" fmla="*/ 1204238 w 1961799"/>
              <a:gd name="connsiteY40" fmla="*/ 1879304 h 1934047"/>
              <a:gd name="connsiteX41" fmla="*/ 1357505 w 1961799"/>
              <a:gd name="connsiteY41" fmla="*/ 1857406 h 1934047"/>
              <a:gd name="connsiteX42" fmla="*/ 1390348 w 1961799"/>
              <a:gd name="connsiteY42" fmla="*/ 1846457 h 1934047"/>
              <a:gd name="connsiteX43" fmla="*/ 1434138 w 1961799"/>
              <a:gd name="connsiteY43" fmla="*/ 1835509 h 1934047"/>
              <a:gd name="connsiteX44" fmla="*/ 1466981 w 1961799"/>
              <a:gd name="connsiteY44" fmla="*/ 1813611 h 1934047"/>
              <a:gd name="connsiteX45" fmla="*/ 1510772 w 1961799"/>
              <a:gd name="connsiteY45" fmla="*/ 1791714 h 1934047"/>
              <a:gd name="connsiteX46" fmla="*/ 1554562 w 1961799"/>
              <a:gd name="connsiteY46" fmla="*/ 1726022 h 1934047"/>
              <a:gd name="connsiteX47" fmla="*/ 1576457 w 1961799"/>
              <a:gd name="connsiteY47" fmla="*/ 1693175 h 1934047"/>
              <a:gd name="connsiteX48" fmla="*/ 1664038 w 1961799"/>
              <a:gd name="connsiteY48" fmla="*/ 1594637 h 1934047"/>
              <a:gd name="connsiteX49" fmla="*/ 1751619 w 1961799"/>
              <a:gd name="connsiteY49" fmla="*/ 1550842 h 1934047"/>
              <a:gd name="connsiteX50" fmla="*/ 1861095 w 1961799"/>
              <a:gd name="connsiteY50" fmla="*/ 1485150 h 1934047"/>
              <a:gd name="connsiteX51" fmla="*/ 1882991 w 1961799"/>
              <a:gd name="connsiteY51" fmla="*/ 1463252 h 1934047"/>
              <a:gd name="connsiteX52" fmla="*/ 1893938 w 1961799"/>
              <a:gd name="connsiteY52" fmla="*/ 1419458 h 1934047"/>
              <a:gd name="connsiteX53" fmla="*/ 1915834 w 1961799"/>
              <a:gd name="connsiteY53" fmla="*/ 1386611 h 1934047"/>
              <a:gd name="connsiteX54" fmla="*/ 1926781 w 1961799"/>
              <a:gd name="connsiteY54" fmla="*/ 1331868 h 1934047"/>
              <a:gd name="connsiteX55" fmla="*/ 1948676 w 1961799"/>
              <a:gd name="connsiteY55" fmla="*/ 1266176 h 1934047"/>
              <a:gd name="connsiteX56" fmla="*/ 1926781 w 1961799"/>
              <a:gd name="connsiteY56" fmla="*/ 1090996 h 1934047"/>
              <a:gd name="connsiteX57" fmla="*/ 1904886 w 1961799"/>
              <a:gd name="connsiteY57" fmla="*/ 1058150 h 1934047"/>
              <a:gd name="connsiteX58" fmla="*/ 1872043 w 1961799"/>
              <a:gd name="connsiteY58" fmla="*/ 948663 h 1934047"/>
              <a:gd name="connsiteX59" fmla="*/ 1861095 w 1961799"/>
              <a:gd name="connsiteY59" fmla="*/ 904868 h 1934047"/>
              <a:gd name="connsiteX60" fmla="*/ 1872043 w 1961799"/>
              <a:gd name="connsiteY60" fmla="*/ 850125 h 1934047"/>
              <a:gd name="connsiteX61" fmla="*/ 1937729 w 1961799"/>
              <a:gd name="connsiteY61" fmla="*/ 795381 h 1934047"/>
              <a:gd name="connsiteX62" fmla="*/ 1926781 w 1961799"/>
              <a:gd name="connsiteY62" fmla="*/ 368381 h 1934047"/>
              <a:gd name="connsiteX63" fmla="*/ 1904886 w 1961799"/>
              <a:gd name="connsiteY63" fmla="*/ 335535 h 1934047"/>
              <a:gd name="connsiteX64" fmla="*/ 1872043 w 1961799"/>
              <a:gd name="connsiteY64" fmla="*/ 291740 h 1934047"/>
              <a:gd name="connsiteX65" fmla="*/ 1828253 w 1961799"/>
              <a:gd name="connsiteY65" fmla="*/ 226048 h 1934047"/>
              <a:gd name="connsiteX66" fmla="*/ 1751619 w 1961799"/>
              <a:gd name="connsiteY66" fmla="*/ 171304 h 1934047"/>
              <a:gd name="connsiteX67" fmla="*/ 1674986 w 1961799"/>
              <a:gd name="connsiteY67" fmla="*/ 138458 h 1934047"/>
              <a:gd name="connsiteX68" fmla="*/ 1609300 w 1961799"/>
              <a:gd name="connsiteY68" fmla="*/ 116561 h 1934047"/>
              <a:gd name="connsiteX69" fmla="*/ 1510772 w 1961799"/>
              <a:gd name="connsiteY69" fmla="*/ 94663 h 1934047"/>
              <a:gd name="connsiteX70" fmla="*/ 1445086 w 1961799"/>
              <a:gd name="connsiteY70" fmla="*/ 72766 h 1934047"/>
              <a:gd name="connsiteX71" fmla="*/ 1401295 w 1961799"/>
              <a:gd name="connsiteY71" fmla="*/ 50868 h 1934047"/>
              <a:gd name="connsiteX72" fmla="*/ 1335610 w 1961799"/>
              <a:gd name="connsiteY72" fmla="*/ 28971 h 1934047"/>
              <a:gd name="connsiteX73" fmla="*/ 1313714 w 1961799"/>
              <a:gd name="connsiteY73" fmla="*/ 7074 h 1934047"/>
              <a:gd name="connsiteX74" fmla="*/ 1248029 w 1961799"/>
              <a:gd name="connsiteY74" fmla="*/ 7074 h 1934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</a:cxnLst>
            <a:rect l="l" t="t" r="r" b="b"/>
            <a:pathLst>
              <a:path w="1961799" h="1934047">
                <a:moveTo>
                  <a:pt x="1248029" y="7074"/>
                </a:moveTo>
                <a:cubicBezTo>
                  <a:pt x="1198765" y="12548"/>
                  <a:pt x="1070457" y="5032"/>
                  <a:pt x="1018129" y="39920"/>
                </a:cubicBezTo>
                <a:cubicBezTo>
                  <a:pt x="1007181" y="47219"/>
                  <a:pt x="995560" y="53597"/>
                  <a:pt x="985286" y="61817"/>
                </a:cubicBezTo>
                <a:cubicBezTo>
                  <a:pt x="977226" y="68266"/>
                  <a:pt x="971451" y="77266"/>
                  <a:pt x="963391" y="83715"/>
                </a:cubicBezTo>
                <a:cubicBezTo>
                  <a:pt x="880018" y="150421"/>
                  <a:pt x="992182" y="43972"/>
                  <a:pt x="886757" y="149407"/>
                </a:cubicBezTo>
                <a:lnTo>
                  <a:pt x="853914" y="182253"/>
                </a:lnTo>
                <a:cubicBezTo>
                  <a:pt x="850265" y="193202"/>
                  <a:pt x="851127" y="206938"/>
                  <a:pt x="842967" y="215099"/>
                </a:cubicBezTo>
                <a:cubicBezTo>
                  <a:pt x="754911" y="303163"/>
                  <a:pt x="772493" y="272579"/>
                  <a:pt x="700648" y="313638"/>
                </a:cubicBezTo>
                <a:cubicBezTo>
                  <a:pt x="575278" y="385286"/>
                  <a:pt x="770828" y="277795"/>
                  <a:pt x="634962" y="368381"/>
                </a:cubicBezTo>
                <a:cubicBezTo>
                  <a:pt x="625360" y="374783"/>
                  <a:pt x="612440" y="374169"/>
                  <a:pt x="602119" y="379330"/>
                </a:cubicBezTo>
                <a:cubicBezTo>
                  <a:pt x="571634" y="394574"/>
                  <a:pt x="560645" y="409859"/>
                  <a:pt x="536433" y="434073"/>
                </a:cubicBezTo>
                <a:cubicBezTo>
                  <a:pt x="521836" y="463270"/>
                  <a:pt x="510748" y="494502"/>
                  <a:pt x="492643" y="521663"/>
                </a:cubicBezTo>
                <a:cubicBezTo>
                  <a:pt x="485345" y="532612"/>
                  <a:pt x="481022" y="546289"/>
                  <a:pt x="470748" y="554509"/>
                </a:cubicBezTo>
                <a:cubicBezTo>
                  <a:pt x="461737" y="561718"/>
                  <a:pt x="448853" y="561808"/>
                  <a:pt x="437905" y="565458"/>
                </a:cubicBezTo>
                <a:cubicBezTo>
                  <a:pt x="430607" y="587355"/>
                  <a:pt x="421608" y="608757"/>
                  <a:pt x="416010" y="631150"/>
                </a:cubicBezTo>
                <a:cubicBezTo>
                  <a:pt x="412361" y="645748"/>
                  <a:pt x="414970" y="663620"/>
                  <a:pt x="405062" y="674945"/>
                </a:cubicBezTo>
                <a:cubicBezTo>
                  <a:pt x="387734" y="694750"/>
                  <a:pt x="357983" y="700131"/>
                  <a:pt x="339376" y="718740"/>
                </a:cubicBezTo>
                <a:cubicBezTo>
                  <a:pt x="328428" y="729689"/>
                  <a:pt x="316444" y="739691"/>
                  <a:pt x="306533" y="751586"/>
                </a:cubicBezTo>
                <a:cubicBezTo>
                  <a:pt x="282286" y="780685"/>
                  <a:pt x="282211" y="794155"/>
                  <a:pt x="262743" y="828227"/>
                </a:cubicBezTo>
                <a:cubicBezTo>
                  <a:pt x="256215" y="839652"/>
                  <a:pt x="248146" y="850124"/>
                  <a:pt x="240848" y="861073"/>
                </a:cubicBezTo>
                <a:cubicBezTo>
                  <a:pt x="238271" y="871382"/>
                  <a:pt x="226092" y="924862"/>
                  <a:pt x="218952" y="937714"/>
                </a:cubicBezTo>
                <a:cubicBezTo>
                  <a:pt x="206173" y="960719"/>
                  <a:pt x="189759" y="981509"/>
                  <a:pt x="175162" y="1003406"/>
                </a:cubicBezTo>
                <a:cubicBezTo>
                  <a:pt x="167864" y="1014355"/>
                  <a:pt x="157428" y="1023770"/>
                  <a:pt x="153267" y="1036253"/>
                </a:cubicBezTo>
                <a:cubicBezTo>
                  <a:pt x="137423" y="1083788"/>
                  <a:pt x="150479" y="1060938"/>
                  <a:pt x="109476" y="1101945"/>
                </a:cubicBezTo>
                <a:lnTo>
                  <a:pt x="87581" y="1167637"/>
                </a:lnTo>
                <a:cubicBezTo>
                  <a:pt x="83932" y="1178586"/>
                  <a:pt x="78896" y="1189166"/>
                  <a:pt x="76633" y="1200483"/>
                </a:cubicBezTo>
                <a:cubicBezTo>
                  <a:pt x="69335" y="1236979"/>
                  <a:pt x="63764" y="1273863"/>
                  <a:pt x="54738" y="1309970"/>
                </a:cubicBezTo>
                <a:cubicBezTo>
                  <a:pt x="20512" y="1446882"/>
                  <a:pt x="64254" y="1276660"/>
                  <a:pt x="32843" y="1386611"/>
                </a:cubicBezTo>
                <a:cubicBezTo>
                  <a:pt x="-244" y="1502429"/>
                  <a:pt x="52026" y="1340002"/>
                  <a:pt x="0" y="1496099"/>
                </a:cubicBezTo>
                <a:cubicBezTo>
                  <a:pt x="7298" y="1558142"/>
                  <a:pt x="1374" y="1623223"/>
                  <a:pt x="21895" y="1682227"/>
                </a:cubicBezTo>
                <a:cubicBezTo>
                  <a:pt x="42302" y="1740902"/>
                  <a:pt x="89829" y="1743850"/>
                  <a:pt x="131371" y="1769816"/>
                </a:cubicBezTo>
                <a:cubicBezTo>
                  <a:pt x="146844" y="1779488"/>
                  <a:pt x="159212" y="1793801"/>
                  <a:pt x="175162" y="1802663"/>
                </a:cubicBezTo>
                <a:cubicBezTo>
                  <a:pt x="218104" y="1826522"/>
                  <a:pt x="230562" y="1822569"/>
                  <a:pt x="273690" y="1835509"/>
                </a:cubicBezTo>
                <a:cubicBezTo>
                  <a:pt x="295796" y="1842142"/>
                  <a:pt x="317481" y="1850107"/>
                  <a:pt x="339376" y="1857406"/>
                </a:cubicBezTo>
                <a:cubicBezTo>
                  <a:pt x="350324" y="1861056"/>
                  <a:pt x="360820" y="1866555"/>
                  <a:pt x="372219" y="1868355"/>
                </a:cubicBezTo>
                <a:cubicBezTo>
                  <a:pt x="623628" y="1908055"/>
                  <a:pt x="510272" y="1895371"/>
                  <a:pt x="711595" y="1912150"/>
                </a:cubicBezTo>
                <a:cubicBezTo>
                  <a:pt x="729841" y="1915799"/>
                  <a:pt x="748169" y="1919061"/>
                  <a:pt x="766333" y="1923098"/>
                </a:cubicBezTo>
                <a:cubicBezTo>
                  <a:pt x="781021" y="1926362"/>
                  <a:pt x="795078" y="1934047"/>
                  <a:pt x="810124" y="1934047"/>
                </a:cubicBezTo>
                <a:cubicBezTo>
                  <a:pt x="908720" y="1934047"/>
                  <a:pt x="1007181" y="1926748"/>
                  <a:pt x="1105710" y="1923098"/>
                </a:cubicBezTo>
                <a:cubicBezTo>
                  <a:pt x="1116657" y="1915799"/>
                  <a:pt x="1126529" y="1906545"/>
                  <a:pt x="1138552" y="1901201"/>
                </a:cubicBezTo>
                <a:cubicBezTo>
                  <a:pt x="1159642" y="1891827"/>
                  <a:pt x="1182343" y="1886603"/>
                  <a:pt x="1204238" y="1879304"/>
                </a:cubicBezTo>
                <a:cubicBezTo>
                  <a:pt x="1275322" y="1855607"/>
                  <a:pt x="1225578" y="1869401"/>
                  <a:pt x="1357505" y="1857406"/>
                </a:cubicBezTo>
                <a:cubicBezTo>
                  <a:pt x="1368453" y="1853756"/>
                  <a:pt x="1379252" y="1849628"/>
                  <a:pt x="1390348" y="1846457"/>
                </a:cubicBezTo>
                <a:cubicBezTo>
                  <a:pt x="1404815" y="1842323"/>
                  <a:pt x="1420309" y="1841436"/>
                  <a:pt x="1434138" y="1835509"/>
                </a:cubicBezTo>
                <a:cubicBezTo>
                  <a:pt x="1446232" y="1830325"/>
                  <a:pt x="1455557" y="1820140"/>
                  <a:pt x="1466981" y="1813611"/>
                </a:cubicBezTo>
                <a:cubicBezTo>
                  <a:pt x="1481151" y="1805513"/>
                  <a:pt x="1496175" y="1799013"/>
                  <a:pt x="1510772" y="1791714"/>
                </a:cubicBezTo>
                <a:lnTo>
                  <a:pt x="1554562" y="1726022"/>
                </a:lnTo>
                <a:lnTo>
                  <a:pt x="1576457" y="1693175"/>
                </a:lnTo>
                <a:cubicBezTo>
                  <a:pt x="1599594" y="1658466"/>
                  <a:pt x="1626549" y="1613383"/>
                  <a:pt x="1664038" y="1594637"/>
                </a:cubicBezTo>
                <a:lnTo>
                  <a:pt x="1751619" y="1550842"/>
                </a:lnTo>
                <a:cubicBezTo>
                  <a:pt x="1786178" y="1533561"/>
                  <a:pt x="1834669" y="1511579"/>
                  <a:pt x="1861095" y="1485150"/>
                </a:cubicBezTo>
                <a:lnTo>
                  <a:pt x="1882991" y="1463252"/>
                </a:lnTo>
                <a:cubicBezTo>
                  <a:pt x="1886640" y="1448654"/>
                  <a:pt x="1888011" y="1433289"/>
                  <a:pt x="1893938" y="1419458"/>
                </a:cubicBezTo>
                <a:cubicBezTo>
                  <a:pt x="1899121" y="1407363"/>
                  <a:pt x="1911214" y="1398932"/>
                  <a:pt x="1915834" y="1386611"/>
                </a:cubicBezTo>
                <a:cubicBezTo>
                  <a:pt x="1922367" y="1369187"/>
                  <a:pt x="1921885" y="1349821"/>
                  <a:pt x="1926781" y="1331868"/>
                </a:cubicBezTo>
                <a:cubicBezTo>
                  <a:pt x="1932853" y="1309600"/>
                  <a:pt x="1941378" y="1288073"/>
                  <a:pt x="1948676" y="1266176"/>
                </a:cubicBezTo>
                <a:cubicBezTo>
                  <a:pt x="1941378" y="1207783"/>
                  <a:pt x="1938903" y="1148582"/>
                  <a:pt x="1926781" y="1090996"/>
                </a:cubicBezTo>
                <a:cubicBezTo>
                  <a:pt x="1924071" y="1078120"/>
                  <a:pt x="1908667" y="1070753"/>
                  <a:pt x="1904886" y="1058150"/>
                </a:cubicBezTo>
                <a:cubicBezTo>
                  <a:pt x="1866461" y="930054"/>
                  <a:pt x="1921313" y="1022576"/>
                  <a:pt x="1872043" y="948663"/>
                </a:cubicBezTo>
                <a:cubicBezTo>
                  <a:pt x="1868394" y="934065"/>
                  <a:pt x="1861095" y="919916"/>
                  <a:pt x="1861095" y="904868"/>
                </a:cubicBezTo>
                <a:cubicBezTo>
                  <a:pt x="1861095" y="886259"/>
                  <a:pt x="1863721" y="866770"/>
                  <a:pt x="1872043" y="850125"/>
                </a:cubicBezTo>
                <a:cubicBezTo>
                  <a:pt x="1882581" y="829047"/>
                  <a:pt x="1918865" y="807958"/>
                  <a:pt x="1937729" y="795381"/>
                </a:cubicBezTo>
                <a:cubicBezTo>
                  <a:pt x="1978116" y="633806"/>
                  <a:pt x="1963018" y="712667"/>
                  <a:pt x="1926781" y="368381"/>
                </a:cubicBezTo>
                <a:cubicBezTo>
                  <a:pt x="1925404" y="355295"/>
                  <a:pt x="1912534" y="346243"/>
                  <a:pt x="1904886" y="335535"/>
                </a:cubicBezTo>
                <a:cubicBezTo>
                  <a:pt x="1894281" y="320686"/>
                  <a:pt x="1882506" y="306689"/>
                  <a:pt x="1872043" y="291740"/>
                </a:cubicBezTo>
                <a:cubicBezTo>
                  <a:pt x="1856953" y="270180"/>
                  <a:pt x="1851791" y="237818"/>
                  <a:pt x="1828253" y="226048"/>
                </a:cubicBezTo>
                <a:cubicBezTo>
                  <a:pt x="1747221" y="185527"/>
                  <a:pt x="1818195" y="226789"/>
                  <a:pt x="1751619" y="171304"/>
                </a:cubicBezTo>
                <a:cubicBezTo>
                  <a:pt x="1715798" y="141450"/>
                  <a:pt x="1720631" y="152153"/>
                  <a:pt x="1674986" y="138458"/>
                </a:cubicBezTo>
                <a:cubicBezTo>
                  <a:pt x="1652880" y="131825"/>
                  <a:pt x="1631932" y="121088"/>
                  <a:pt x="1609300" y="116561"/>
                </a:cubicBezTo>
                <a:cubicBezTo>
                  <a:pt x="1578043" y="110309"/>
                  <a:pt x="1541697" y="103941"/>
                  <a:pt x="1510772" y="94663"/>
                </a:cubicBezTo>
                <a:cubicBezTo>
                  <a:pt x="1488666" y="88030"/>
                  <a:pt x="1465729" y="83089"/>
                  <a:pt x="1445086" y="72766"/>
                </a:cubicBezTo>
                <a:cubicBezTo>
                  <a:pt x="1430489" y="65467"/>
                  <a:pt x="1416448" y="56930"/>
                  <a:pt x="1401295" y="50868"/>
                </a:cubicBezTo>
                <a:cubicBezTo>
                  <a:pt x="1379866" y="42296"/>
                  <a:pt x="1335610" y="28971"/>
                  <a:pt x="1335610" y="28971"/>
                </a:cubicBezTo>
                <a:cubicBezTo>
                  <a:pt x="1328311" y="21672"/>
                  <a:pt x="1322946" y="11691"/>
                  <a:pt x="1313714" y="7074"/>
                </a:cubicBezTo>
                <a:cubicBezTo>
                  <a:pt x="1288278" y="-5645"/>
                  <a:pt x="1297293" y="1600"/>
                  <a:pt x="1248029" y="7074"/>
                </a:cubicBezTo>
                <a:close/>
              </a:path>
            </a:pathLst>
          </a:custGeom>
          <a:noFill/>
          <a:ln>
            <a:solidFill>
              <a:schemeClr val="bg1"/>
            </a:solidFill>
            <a:prstDash val="dash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sp>
        <p:nvSpPr>
          <p:cNvPr id="189" name="Forme libre 188"/>
          <p:cNvSpPr/>
          <p:nvPr/>
        </p:nvSpPr>
        <p:spPr>
          <a:xfrm>
            <a:off x="2574291" y="3933839"/>
            <a:ext cx="1961799" cy="1934047"/>
          </a:xfrm>
          <a:custGeom>
            <a:avLst/>
            <a:gdLst>
              <a:gd name="connsiteX0" fmla="*/ 1248029 w 1961799"/>
              <a:gd name="connsiteY0" fmla="*/ 7074 h 1934047"/>
              <a:gd name="connsiteX1" fmla="*/ 1018129 w 1961799"/>
              <a:gd name="connsiteY1" fmla="*/ 39920 h 1934047"/>
              <a:gd name="connsiteX2" fmla="*/ 985286 w 1961799"/>
              <a:gd name="connsiteY2" fmla="*/ 61817 h 1934047"/>
              <a:gd name="connsiteX3" fmla="*/ 963391 w 1961799"/>
              <a:gd name="connsiteY3" fmla="*/ 83715 h 1934047"/>
              <a:gd name="connsiteX4" fmla="*/ 886757 w 1961799"/>
              <a:gd name="connsiteY4" fmla="*/ 149407 h 1934047"/>
              <a:gd name="connsiteX5" fmla="*/ 853914 w 1961799"/>
              <a:gd name="connsiteY5" fmla="*/ 182253 h 1934047"/>
              <a:gd name="connsiteX6" fmla="*/ 842967 w 1961799"/>
              <a:gd name="connsiteY6" fmla="*/ 215099 h 1934047"/>
              <a:gd name="connsiteX7" fmla="*/ 700648 w 1961799"/>
              <a:gd name="connsiteY7" fmla="*/ 313638 h 1934047"/>
              <a:gd name="connsiteX8" fmla="*/ 634962 w 1961799"/>
              <a:gd name="connsiteY8" fmla="*/ 368381 h 1934047"/>
              <a:gd name="connsiteX9" fmla="*/ 602119 w 1961799"/>
              <a:gd name="connsiteY9" fmla="*/ 379330 h 1934047"/>
              <a:gd name="connsiteX10" fmla="*/ 536433 w 1961799"/>
              <a:gd name="connsiteY10" fmla="*/ 434073 h 1934047"/>
              <a:gd name="connsiteX11" fmla="*/ 492643 w 1961799"/>
              <a:gd name="connsiteY11" fmla="*/ 521663 h 1934047"/>
              <a:gd name="connsiteX12" fmla="*/ 470748 w 1961799"/>
              <a:gd name="connsiteY12" fmla="*/ 554509 h 1934047"/>
              <a:gd name="connsiteX13" fmla="*/ 437905 w 1961799"/>
              <a:gd name="connsiteY13" fmla="*/ 565458 h 1934047"/>
              <a:gd name="connsiteX14" fmla="*/ 416010 w 1961799"/>
              <a:gd name="connsiteY14" fmla="*/ 631150 h 1934047"/>
              <a:gd name="connsiteX15" fmla="*/ 405062 w 1961799"/>
              <a:gd name="connsiteY15" fmla="*/ 674945 h 1934047"/>
              <a:gd name="connsiteX16" fmla="*/ 339376 w 1961799"/>
              <a:gd name="connsiteY16" fmla="*/ 718740 h 1934047"/>
              <a:gd name="connsiteX17" fmla="*/ 306533 w 1961799"/>
              <a:gd name="connsiteY17" fmla="*/ 751586 h 1934047"/>
              <a:gd name="connsiteX18" fmla="*/ 262743 w 1961799"/>
              <a:gd name="connsiteY18" fmla="*/ 828227 h 1934047"/>
              <a:gd name="connsiteX19" fmla="*/ 240848 w 1961799"/>
              <a:gd name="connsiteY19" fmla="*/ 861073 h 1934047"/>
              <a:gd name="connsiteX20" fmla="*/ 218952 w 1961799"/>
              <a:gd name="connsiteY20" fmla="*/ 937714 h 1934047"/>
              <a:gd name="connsiteX21" fmla="*/ 175162 w 1961799"/>
              <a:gd name="connsiteY21" fmla="*/ 1003406 h 1934047"/>
              <a:gd name="connsiteX22" fmla="*/ 153267 w 1961799"/>
              <a:gd name="connsiteY22" fmla="*/ 1036253 h 1934047"/>
              <a:gd name="connsiteX23" fmla="*/ 109476 w 1961799"/>
              <a:gd name="connsiteY23" fmla="*/ 1101945 h 1934047"/>
              <a:gd name="connsiteX24" fmla="*/ 87581 w 1961799"/>
              <a:gd name="connsiteY24" fmla="*/ 1167637 h 1934047"/>
              <a:gd name="connsiteX25" fmla="*/ 76633 w 1961799"/>
              <a:gd name="connsiteY25" fmla="*/ 1200483 h 1934047"/>
              <a:gd name="connsiteX26" fmla="*/ 54738 w 1961799"/>
              <a:gd name="connsiteY26" fmla="*/ 1309970 h 1934047"/>
              <a:gd name="connsiteX27" fmla="*/ 32843 w 1961799"/>
              <a:gd name="connsiteY27" fmla="*/ 1386611 h 1934047"/>
              <a:gd name="connsiteX28" fmla="*/ 0 w 1961799"/>
              <a:gd name="connsiteY28" fmla="*/ 1496099 h 1934047"/>
              <a:gd name="connsiteX29" fmla="*/ 21895 w 1961799"/>
              <a:gd name="connsiteY29" fmla="*/ 1682227 h 1934047"/>
              <a:gd name="connsiteX30" fmla="*/ 131371 w 1961799"/>
              <a:gd name="connsiteY30" fmla="*/ 1769816 h 1934047"/>
              <a:gd name="connsiteX31" fmla="*/ 175162 w 1961799"/>
              <a:gd name="connsiteY31" fmla="*/ 1802663 h 1934047"/>
              <a:gd name="connsiteX32" fmla="*/ 273690 w 1961799"/>
              <a:gd name="connsiteY32" fmla="*/ 1835509 h 1934047"/>
              <a:gd name="connsiteX33" fmla="*/ 339376 w 1961799"/>
              <a:gd name="connsiteY33" fmla="*/ 1857406 h 1934047"/>
              <a:gd name="connsiteX34" fmla="*/ 372219 w 1961799"/>
              <a:gd name="connsiteY34" fmla="*/ 1868355 h 1934047"/>
              <a:gd name="connsiteX35" fmla="*/ 711595 w 1961799"/>
              <a:gd name="connsiteY35" fmla="*/ 1912150 h 1934047"/>
              <a:gd name="connsiteX36" fmla="*/ 766333 w 1961799"/>
              <a:gd name="connsiteY36" fmla="*/ 1923098 h 1934047"/>
              <a:gd name="connsiteX37" fmla="*/ 810124 w 1961799"/>
              <a:gd name="connsiteY37" fmla="*/ 1934047 h 1934047"/>
              <a:gd name="connsiteX38" fmla="*/ 1105710 w 1961799"/>
              <a:gd name="connsiteY38" fmla="*/ 1923098 h 1934047"/>
              <a:gd name="connsiteX39" fmla="*/ 1138552 w 1961799"/>
              <a:gd name="connsiteY39" fmla="*/ 1901201 h 1934047"/>
              <a:gd name="connsiteX40" fmla="*/ 1204238 w 1961799"/>
              <a:gd name="connsiteY40" fmla="*/ 1879304 h 1934047"/>
              <a:gd name="connsiteX41" fmla="*/ 1357505 w 1961799"/>
              <a:gd name="connsiteY41" fmla="*/ 1857406 h 1934047"/>
              <a:gd name="connsiteX42" fmla="*/ 1390348 w 1961799"/>
              <a:gd name="connsiteY42" fmla="*/ 1846457 h 1934047"/>
              <a:gd name="connsiteX43" fmla="*/ 1434138 w 1961799"/>
              <a:gd name="connsiteY43" fmla="*/ 1835509 h 1934047"/>
              <a:gd name="connsiteX44" fmla="*/ 1466981 w 1961799"/>
              <a:gd name="connsiteY44" fmla="*/ 1813611 h 1934047"/>
              <a:gd name="connsiteX45" fmla="*/ 1510772 w 1961799"/>
              <a:gd name="connsiteY45" fmla="*/ 1791714 h 1934047"/>
              <a:gd name="connsiteX46" fmla="*/ 1554562 w 1961799"/>
              <a:gd name="connsiteY46" fmla="*/ 1726022 h 1934047"/>
              <a:gd name="connsiteX47" fmla="*/ 1576457 w 1961799"/>
              <a:gd name="connsiteY47" fmla="*/ 1693175 h 1934047"/>
              <a:gd name="connsiteX48" fmla="*/ 1664038 w 1961799"/>
              <a:gd name="connsiteY48" fmla="*/ 1594637 h 1934047"/>
              <a:gd name="connsiteX49" fmla="*/ 1751619 w 1961799"/>
              <a:gd name="connsiteY49" fmla="*/ 1550842 h 1934047"/>
              <a:gd name="connsiteX50" fmla="*/ 1861095 w 1961799"/>
              <a:gd name="connsiteY50" fmla="*/ 1485150 h 1934047"/>
              <a:gd name="connsiteX51" fmla="*/ 1882991 w 1961799"/>
              <a:gd name="connsiteY51" fmla="*/ 1463252 h 1934047"/>
              <a:gd name="connsiteX52" fmla="*/ 1893938 w 1961799"/>
              <a:gd name="connsiteY52" fmla="*/ 1419458 h 1934047"/>
              <a:gd name="connsiteX53" fmla="*/ 1915834 w 1961799"/>
              <a:gd name="connsiteY53" fmla="*/ 1386611 h 1934047"/>
              <a:gd name="connsiteX54" fmla="*/ 1926781 w 1961799"/>
              <a:gd name="connsiteY54" fmla="*/ 1331868 h 1934047"/>
              <a:gd name="connsiteX55" fmla="*/ 1948676 w 1961799"/>
              <a:gd name="connsiteY55" fmla="*/ 1266176 h 1934047"/>
              <a:gd name="connsiteX56" fmla="*/ 1926781 w 1961799"/>
              <a:gd name="connsiteY56" fmla="*/ 1090996 h 1934047"/>
              <a:gd name="connsiteX57" fmla="*/ 1904886 w 1961799"/>
              <a:gd name="connsiteY57" fmla="*/ 1058150 h 1934047"/>
              <a:gd name="connsiteX58" fmla="*/ 1872043 w 1961799"/>
              <a:gd name="connsiteY58" fmla="*/ 948663 h 1934047"/>
              <a:gd name="connsiteX59" fmla="*/ 1861095 w 1961799"/>
              <a:gd name="connsiteY59" fmla="*/ 904868 h 1934047"/>
              <a:gd name="connsiteX60" fmla="*/ 1872043 w 1961799"/>
              <a:gd name="connsiteY60" fmla="*/ 850125 h 1934047"/>
              <a:gd name="connsiteX61" fmla="*/ 1937729 w 1961799"/>
              <a:gd name="connsiteY61" fmla="*/ 795381 h 1934047"/>
              <a:gd name="connsiteX62" fmla="*/ 1926781 w 1961799"/>
              <a:gd name="connsiteY62" fmla="*/ 368381 h 1934047"/>
              <a:gd name="connsiteX63" fmla="*/ 1904886 w 1961799"/>
              <a:gd name="connsiteY63" fmla="*/ 335535 h 1934047"/>
              <a:gd name="connsiteX64" fmla="*/ 1872043 w 1961799"/>
              <a:gd name="connsiteY64" fmla="*/ 291740 h 1934047"/>
              <a:gd name="connsiteX65" fmla="*/ 1828253 w 1961799"/>
              <a:gd name="connsiteY65" fmla="*/ 226048 h 1934047"/>
              <a:gd name="connsiteX66" fmla="*/ 1751619 w 1961799"/>
              <a:gd name="connsiteY66" fmla="*/ 171304 h 1934047"/>
              <a:gd name="connsiteX67" fmla="*/ 1674986 w 1961799"/>
              <a:gd name="connsiteY67" fmla="*/ 138458 h 1934047"/>
              <a:gd name="connsiteX68" fmla="*/ 1609300 w 1961799"/>
              <a:gd name="connsiteY68" fmla="*/ 116561 h 1934047"/>
              <a:gd name="connsiteX69" fmla="*/ 1510772 w 1961799"/>
              <a:gd name="connsiteY69" fmla="*/ 94663 h 1934047"/>
              <a:gd name="connsiteX70" fmla="*/ 1445086 w 1961799"/>
              <a:gd name="connsiteY70" fmla="*/ 72766 h 1934047"/>
              <a:gd name="connsiteX71" fmla="*/ 1401295 w 1961799"/>
              <a:gd name="connsiteY71" fmla="*/ 50868 h 1934047"/>
              <a:gd name="connsiteX72" fmla="*/ 1335610 w 1961799"/>
              <a:gd name="connsiteY72" fmla="*/ 28971 h 1934047"/>
              <a:gd name="connsiteX73" fmla="*/ 1313714 w 1961799"/>
              <a:gd name="connsiteY73" fmla="*/ 7074 h 1934047"/>
              <a:gd name="connsiteX74" fmla="*/ 1248029 w 1961799"/>
              <a:gd name="connsiteY74" fmla="*/ 7074 h 1934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</a:cxnLst>
            <a:rect l="l" t="t" r="r" b="b"/>
            <a:pathLst>
              <a:path w="1961799" h="1934047">
                <a:moveTo>
                  <a:pt x="1248029" y="7074"/>
                </a:moveTo>
                <a:cubicBezTo>
                  <a:pt x="1198765" y="12548"/>
                  <a:pt x="1070457" y="5032"/>
                  <a:pt x="1018129" y="39920"/>
                </a:cubicBezTo>
                <a:cubicBezTo>
                  <a:pt x="1007181" y="47219"/>
                  <a:pt x="995560" y="53597"/>
                  <a:pt x="985286" y="61817"/>
                </a:cubicBezTo>
                <a:cubicBezTo>
                  <a:pt x="977226" y="68266"/>
                  <a:pt x="971451" y="77266"/>
                  <a:pt x="963391" y="83715"/>
                </a:cubicBezTo>
                <a:cubicBezTo>
                  <a:pt x="880018" y="150421"/>
                  <a:pt x="992182" y="43972"/>
                  <a:pt x="886757" y="149407"/>
                </a:cubicBezTo>
                <a:lnTo>
                  <a:pt x="853914" y="182253"/>
                </a:lnTo>
                <a:cubicBezTo>
                  <a:pt x="850265" y="193202"/>
                  <a:pt x="851127" y="206938"/>
                  <a:pt x="842967" y="215099"/>
                </a:cubicBezTo>
                <a:cubicBezTo>
                  <a:pt x="754911" y="303163"/>
                  <a:pt x="772493" y="272579"/>
                  <a:pt x="700648" y="313638"/>
                </a:cubicBezTo>
                <a:cubicBezTo>
                  <a:pt x="575278" y="385286"/>
                  <a:pt x="770828" y="277795"/>
                  <a:pt x="634962" y="368381"/>
                </a:cubicBezTo>
                <a:cubicBezTo>
                  <a:pt x="625360" y="374783"/>
                  <a:pt x="612440" y="374169"/>
                  <a:pt x="602119" y="379330"/>
                </a:cubicBezTo>
                <a:cubicBezTo>
                  <a:pt x="571634" y="394574"/>
                  <a:pt x="560645" y="409859"/>
                  <a:pt x="536433" y="434073"/>
                </a:cubicBezTo>
                <a:cubicBezTo>
                  <a:pt x="521836" y="463270"/>
                  <a:pt x="510748" y="494502"/>
                  <a:pt x="492643" y="521663"/>
                </a:cubicBezTo>
                <a:cubicBezTo>
                  <a:pt x="485345" y="532612"/>
                  <a:pt x="481022" y="546289"/>
                  <a:pt x="470748" y="554509"/>
                </a:cubicBezTo>
                <a:cubicBezTo>
                  <a:pt x="461737" y="561718"/>
                  <a:pt x="448853" y="561808"/>
                  <a:pt x="437905" y="565458"/>
                </a:cubicBezTo>
                <a:cubicBezTo>
                  <a:pt x="430607" y="587355"/>
                  <a:pt x="421608" y="608757"/>
                  <a:pt x="416010" y="631150"/>
                </a:cubicBezTo>
                <a:cubicBezTo>
                  <a:pt x="412361" y="645748"/>
                  <a:pt x="414970" y="663620"/>
                  <a:pt x="405062" y="674945"/>
                </a:cubicBezTo>
                <a:cubicBezTo>
                  <a:pt x="387734" y="694750"/>
                  <a:pt x="357983" y="700131"/>
                  <a:pt x="339376" y="718740"/>
                </a:cubicBezTo>
                <a:cubicBezTo>
                  <a:pt x="328428" y="729689"/>
                  <a:pt x="316444" y="739691"/>
                  <a:pt x="306533" y="751586"/>
                </a:cubicBezTo>
                <a:cubicBezTo>
                  <a:pt x="282286" y="780685"/>
                  <a:pt x="282211" y="794155"/>
                  <a:pt x="262743" y="828227"/>
                </a:cubicBezTo>
                <a:cubicBezTo>
                  <a:pt x="256215" y="839652"/>
                  <a:pt x="248146" y="850124"/>
                  <a:pt x="240848" y="861073"/>
                </a:cubicBezTo>
                <a:cubicBezTo>
                  <a:pt x="238271" y="871382"/>
                  <a:pt x="226092" y="924862"/>
                  <a:pt x="218952" y="937714"/>
                </a:cubicBezTo>
                <a:cubicBezTo>
                  <a:pt x="206173" y="960719"/>
                  <a:pt x="189759" y="981509"/>
                  <a:pt x="175162" y="1003406"/>
                </a:cubicBezTo>
                <a:cubicBezTo>
                  <a:pt x="167864" y="1014355"/>
                  <a:pt x="157428" y="1023770"/>
                  <a:pt x="153267" y="1036253"/>
                </a:cubicBezTo>
                <a:cubicBezTo>
                  <a:pt x="137423" y="1083788"/>
                  <a:pt x="150479" y="1060938"/>
                  <a:pt x="109476" y="1101945"/>
                </a:cubicBezTo>
                <a:lnTo>
                  <a:pt x="87581" y="1167637"/>
                </a:lnTo>
                <a:cubicBezTo>
                  <a:pt x="83932" y="1178586"/>
                  <a:pt x="78896" y="1189166"/>
                  <a:pt x="76633" y="1200483"/>
                </a:cubicBezTo>
                <a:cubicBezTo>
                  <a:pt x="69335" y="1236979"/>
                  <a:pt x="63764" y="1273863"/>
                  <a:pt x="54738" y="1309970"/>
                </a:cubicBezTo>
                <a:cubicBezTo>
                  <a:pt x="20512" y="1446882"/>
                  <a:pt x="64254" y="1276660"/>
                  <a:pt x="32843" y="1386611"/>
                </a:cubicBezTo>
                <a:cubicBezTo>
                  <a:pt x="-244" y="1502429"/>
                  <a:pt x="52026" y="1340002"/>
                  <a:pt x="0" y="1496099"/>
                </a:cubicBezTo>
                <a:cubicBezTo>
                  <a:pt x="7298" y="1558142"/>
                  <a:pt x="1374" y="1623223"/>
                  <a:pt x="21895" y="1682227"/>
                </a:cubicBezTo>
                <a:cubicBezTo>
                  <a:pt x="42302" y="1740902"/>
                  <a:pt x="89829" y="1743850"/>
                  <a:pt x="131371" y="1769816"/>
                </a:cubicBezTo>
                <a:cubicBezTo>
                  <a:pt x="146844" y="1779488"/>
                  <a:pt x="159212" y="1793801"/>
                  <a:pt x="175162" y="1802663"/>
                </a:cubicBezTo>
                <a:cubicBezTo>
                  <a:pt x="218104" y="1826522"/>
                  <a:pt x="230562" y="1822569"/>
                  <a:pt x="273690" y="1835509"/>
                </a:cubicBezTo>
                <a:cubicBezTo>
                  <a:pt x="295796" y="1842142"/>
                  <a:pt x="317481" y="1850107"/>
                  <a:pt x="339376" y="1857406"/>
                </a:cubicBezTo>
                <a:cubicBezTo>
                  <a:pt x="350324" y="1861056"/>
                  <a:pt x="360820" y="1866555"/>
                  <a:pt x="372219" y="1868355"/>
                </a:cubicBezTo>
                <a:cubicBezTo>
                  <a:pt x="623628" y="1908055"/>
                  <a:pt x="510272" y="1895371"/>
                  <a:pt x="711595" y="1912150"/>
                </a:cubicBezTo>
                <a:cubicBezTo>
                  <a:pt x="729841" y="1915799"/>
                  <a:pt x="748169" y="1919061"/>
                  <a:pt x="766333" y="1923098"/>
                </a:cubicBezTo>
                <a:cubicBezTo>
                  <a:pt x="781021" y="1926362"/>
                  <a:pt x="795078" y="1934047"/>
                  <a:pt x="810124" y="1934047"/>
                </a:cubicBezTo>
                <a:cubicBezTo>
                  <a:pt x="908720" y="1934047"/>
                  <a:pt x="1007181" y="1926748"/>
                  <a:pt x="1105710" y="1923098"/>
                </a:cubicBezTo>
                <a:cubicBezTo>
                  <a:pt x="1116657" y="1915799"/>
                  <a:pt x="1126529" y="1906545"/>
                  <a:pt x="1138552" y="1901201"/>
                </a:cubicBezTo>
                <a:cubicBezTo>
                  <a:pt x="1159642" y="1891827"/>
                  <a:pt x="1182343" y="1886603"/>
                  <a:pt x="1204238" y="1879304"/>
                </a:cubicBezTo>
                <a:cubicBezTo>
                  <a:pt x="1275322" y="1855607"/>
                  <a:pt x="1225578" y="1869401"/>
                  <a:pt x="1357505" y="1857406"/>
                </a:cubicBezTo>
                <a:cubicBezTo>
                  <a:pt x="1368453" y="1853756"/>
                  <a:pt x="1379252" y="1849628"/>
                  <a:pt x="1390348" y="1846457"/>
                </a:cubicBezTo>
                <a:cubicBezTo>
                  <a:pt x="1404815" y="1842323"/>
                  <a:pt x="1420309" y="1841436"/>
                  <a:pt x="1434138" y="1835509"/>
                </a:cubicBezTo>
                <a:cubicBezTo>
                  <a:pt x="1446232" y="1830325"/>
                  <a:pt x="1455557" y="1820140"/>
                  <a:pt x="1466981" y="1813611"/>
                </a:cubicBezTo>
                <a:cubicBezTo>
                  <a:pt x="1481151" y="1805513"/>
                  <a:pt x="1496175" y="1799013"/>
                  <a:pt x="1510772" y="1791714"/>
                </a:cubicBezTo>
                <a:lnTo>
                  <a:pt x="1554562" y="1726022"/>
                </a:lnTo>
                <a:lnTo>
                  <a:pt x="1576457" y="1693175"/>
                </a:lnTo>
                <a:cubicBezTo>
                  <a:pt x="1599594" y="1658466"/>
                  <a:pt x="1626549" y="1613383"/>
                  <a:pt x="1664038" y="1594637"/>
                </a:cubicBezTo>
                <a:lnTo>
                  <a:pt x="1751619" y="1550842"/>
                </a:lnTo>
                <a:cubicBezTo>
                  <a:pt x="1786178" y="1533561"/>
                  <a:pt x="1834669" y="1511579"/>
                  <a:pt x="1861095" y="1485150"/>
                </a:cubicBezTo>
                <a:lnTo>
                  <a:pt x="1882991" y="1463252"/>
                </a:lnTo>
                <a:cubicBezTo>
                  <a:pt x="1886640" y="1448654"/>
                  <a:pt x="1888011" y="1433289"/>
                  <a:pt x="1893938" y="1419458"/>
                </a:cubicBezTo>
                <a:cubicBezTo>
                  <a:pt x="1899121" y="1407363"/>
                  <a:pt x="1911214" y="1398932"/>
                  <a:pt x="1915834" y="1386611"/>
                </a:cubicBezTo>
                <a:cubicBezTo>
                  <a:pt x="1922367" y="1369187"/>
                  <a:pt x="1921885" y="1349821"/>
                  <a:pt x="1926781" y="1331868"/>
                </a:cubicBezTo>
                <a:cubicBezTo>
                  <a:pt x="1932853" y="1309600"/>
                  <a:pt x="1941378" y="1288073"/>
                  <a:pt x="1948676" y="1266176"/>
                </a:cubicBezTo>
                <a:cubicBezTo>
                  <a:pt x="1941378" y="1207783"/>
                  <a:pt x="1938903" y="1148582"/>
                  <a:pt x="1926781" y="1090996"/>
                </a:cubicBezTo>
                <a:cubicBezTo>
                  <a:pt x="1924071" y="1078120"/>
                  <a:pt x="1908667" y="1070753"/>
                  <a:pt x="1904886" y="1058150"/>
                </a:cubicBezTo>
                <a:cubicBezTo>
                  <a:pt x="1866461" y="930054"/>
                  <a:pt x="1921313" y="1022576"/>
                  <a:pt x="1872043" y="948663"/>
                </a:cubicBezTo>
                <a:cubicBezTo>
                  <a:pt x="1868394" y="934065"/>
                  <a:pt x="1861095" y="919916"/>
                  <a:pt x="1861095" y="904868"/>
                </a:cubicBezTo>
                <a:cubicBezTo>
                  <a:pt x="1861095" y="886259"/>
                  <a:pt x="1863721" y="866770"/>
                  <a:pt x="1872043" y="850125"/>
                </a:cubicBezTo>
                <a:cubicBezTo>
                  <a:pt x="1882581" y="829047"/>
                  <a:pt x="1918865" y="807958"/>
                  <a:pt x="1937729" y="795381"/>
                </a:cubicBezTo>
                <a:cubicBezTo>
                  <a:pt x="1978116" y="633806"/>
                  <a:pt x="1963018" y="712667"/>
                  <a:pt x="1926781" y="368381"/>
                </a:cubicBezTo>
                <a:cubicBezTo>
                  <a:pt x="1925404" y="355295"/>
                  <a:pt x="1912534" y="346243"/>
                  <a:pt x="1904886" y="335535"/>
                </a:cubicBezTo>
                <a:cubicBezTo>
                  <a:pt x="1894281" y="320686"/>
                  <a:pt x="1882506" y="306689"/>
                  <a:pt x="1872043" y="291740"/>
                </a:cubicBezTo>
                <a:cubicBezTo>
                  <a:pt x="1856953" y="270180"/>
                  <a:pt x="1851791" y="237818"/>
                  <a:pt x="1828253" y="226048"/>
                </a:cubicBezTo>
                <a:cubicBezTo>
                  <a:pt x="1747221" y="185527"/>
                  <a:pt x="1818195" y="226789"/>
                  <a:pt x="1751619" y="171304"/>
                </a:cubicBezTo>
                <a:cubicBezTo>
                  <a:pt x="1715798" y="141450"/>
                  <a:pt x="1720631" y="152153"/>
                  <a:pt x="1674986" y="138458"/>
                </a:cubicBezTo>
                <a:cubicBezTo>
                  <a:pt x="1652880" y="131825"/>
                  <a:pt x="1631932" y="121088"/>
                  <a:pt x="1609300" y="116561"/>
                </a:cubicBezTo>
                <a:cubicBezTo>
                  <a:pt x="1578043" y="110309"/>
                  <a:pt x="1541697" y="103941"/>
                  <a:pt x="1510772" y="94663"/>
                </a:cubicBezTo>
                <a:cubicBezTo>
                  <a:pt x="1488666" y="88030"/>
                  <a:pt x="1465729" y="83089"/>
                  <a:pt x="1445086" y="72766"/>
                </a:cubicBezTo>
                <a:cubicBezTo>
                  <a:pt x="1430489" y="65467"/>
                  <a:pt x="1416448" y="56930"/>
                  <a:pt x="1401295" y="50868"/>
                </a:cubicBezTo>
                <a:cubicBezTo>
                  <a:pt x="1379866" y="42296"/>
                  <a:pt x="1335610" y="28971"/>
                  <a:pt x="1335610" y="28971"/>
                </a:cubicBezTo>
                <a:cubicBezTo>
                  <a:pt x="1328311" y="21672"/>
                  <a:pt x="1322946" y="11691"/>
                  <a:pt x="1313714" y="7074"/>
                </a:cubicBezTo>
                <a:cubicBezTo>
                  <a:pt x="1288278" y="-5645"/>
                  <a:pt x="1297293" y="1600"/>
                  <a:pt x="1248029" y="7074"/>
                </a:cubicBezTo>
                <a:close/>
              </a:path>
            </a:pathLst>
          </a:custGeom>
          <a:noFill/>
          <a:ln>
            <a:solidFill>
              <a:schemeClr val="bg1"/>
            </a:solidFill>
            <a:prstDash val="dash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sp>
        <p:nvSpPr>
          <p:cNvPr id="205" name="Forme libre 204"/>
          <p:cNvSpPr/>
          <p:nvPr/>
        </p:nvSpPr>
        <p:spPr>
          <a:xfrm>
            <a:off x="464137" y="3933839"/>
            <a:ext cx="1961799" cy="1934047"/>
          </a:xfrm>
          <a:custGeom>
            <a:avLst/>
            <a:gdLst>
              <a:gd name="connsiteX0" fmla="*/ 1248029 w 1961799"/>
              <a:gd name="connsiteY0" fmla="*/ 7074 h 1934047"/>
              <a:gd name="connsiteX1" fmla="*/ 1018129 w 1961799"/>
              <a:gd name="connsiteY1" fmla="*/ 39920 h 1934047"/>
              <a:gd name="connsiteX2" fmla="*/ 985286 w 1961799"/>
              <a:gd name="connsiteY2" fmla="*/ 61817 h 1934047"/>
              <a:gd name="connsiteX3" fmla="*/ 963391 w 1961799"/>
              <a:gd name="connsiteY3" fmla="*/ 83715 h 1934047"/>
              <a:gd name="connsiteX4" fmla="*/ 886757 w 1961799"/>
              <a:gd name="connsiteY4" fmla="*/ 149407 h 1934047"/>
              <a:gd name="connsiteX5" fmla="*/ 853914 w 1961799"/>
              <a:gd name="connsiteY5" fmla="*/ 182253 h 1934047"/>
              <a:gd name="connsiteX6" fmla="*/ 842967 w 1961799"/>
              <a:gd name="connsiteY6" fmla="*/ 215099 h 1934047"/>
              <a:gd name="connsiteX7" fmla="*/ 700648 w 1961799"/>
              <a:gd name="connsiteY7" fmla="*/ 313638 h 1934047"/>
              <a:gd name="connsiteX8" fmla="*/ 634962 w 1961799"/>
              <a:gd name="connsiteY8" fmla="*/ 368381 h 1934047"/>
              <a:gd name="connsiteX9" fmla="*/ 602119 w 1961799"/>
              <a:gd name="connsiteY9" fmla="*/ 379330 h 1934047"/>
              <a:gd name="connsiteX10" fmla="*/ 536433 w 1961799"/>
              <a:gd name="connsiteY10" fmla="*/ 434073 h 1934047"/>
              <a:gd name="connsiteX11" fmla="*/ 492643 w 1961799"/>
              <a:gd name="connsiteY11" fmla="*/ 521663 h 1934047"/>
              <a:gd name="connsiteX12" fmla="*/ 470748 w 1961799"/>
              <a:gd name="connsiteY12" fmla="*/ 554509 h 1934047"/>
              <a:gd name="connsiteX13" fmla="*/ 437905 w 1961799"/>
              <a:gd name="connsiteY13" fmla="*/ 565458 h 1934047"/>
              <a:gd name="connsiteX14" fmla="*/ 416010 w 1961799"/>
              <a:gd name="connsiteY14" fmla="*/ 631150 h 1934047"/>
              <a:gd name="connsiteX15" fmla="*/ 405062 w 1961799"/>
              <a:gd name="connsiteY15" fmla="*/ 674945 h 1934047"/>
              <a:gd name="connsiteX16" fmla="*/ 339376 w 1961799"/>
              <a:gd name="connsiteY16" fmla="*/ 718740 h 1934047"/>
              <a:gd name="connsiteX17" fmla="*/ 306533 w 1961799"/>
              <a:gd name="connsiteY17" fmla="*/ 751586 h 1934047"/>
              <a:gd name="connsiteX18" fmla="*/ 262743 w 1961799"/>
              <a:gd name="connsiteY18" fmla="*/ 828227 h 1934047"/>
              <a:gd name="connsiteX19" fmla="*/ 240848 w 1961799"/>
              <a:gd name="connsiteY19" fmla="*/ 861073 h 1934047"/>
              <a:gd name="connsiteX20" fmla="*/ 218952 w 1961799"/>
              <a:gd name="connsiteY20" fmla="*/ 937714 h 1934047"/>
              <a:gd name="connsiteX21" fmla="*/ 175162 w 1961799"/>
              <a:gd name="connsiteY21" fmla="*/ 1003406 h 1934047"/>
              <a:gd name="connsiteX22" fmla="*/ 153267 w 1961799"/>
              <a:gd name="connsiteY22" fmla="*/ 1036253 h 1934047"/>
              <a:gd name="connsiteX23" fmla="*/ 109476 w 1961799"/>
              <a:gd name="connsiteY23" fmla="*/ 1101945 h 1934047"/>
              <a:gd name="connsiteX24" fmla="*/ 87581 w 1961799"/>
              <a:gd name="connsiteY24" fmla="*/ 1167637 h 1934047"/>
              <a:gd name="connsiteX25" fmla="*/ 76633 w 1961799"/>
              <a:gd name="connsiteY25" fmla="*/ 1200483 h 1934047"/>
              <a:gd name="connsiteX26" fmla="*/ 54738 w 1961799"/>
              <a:gd name="connsiteY26" fmla="*/ 1309970 h 1934047"/>
              <a:gd name="connsiteX27" fmla="*/ 32843 w 1961799"/>
              <a:gd name="connsiteY27" fmla="*/ 1386611 h 1934047"/>
              <a:gd name="connsiteX28" fmla="*/ 0 w 1961799"/>
              <a:gd name="connsiteY28" fmla="*/ 1496099 h 1934047"/>
              <a:gd name="connsiteX29" fmla="*/ 21895 w 1961799"/>
              <a:gd name="connsiteY29" fmla="*/ 1682227 h 1934047"/>
              <a:gd name="connsiteX30" fmla="*/ 131371 w 1961799"/>
              <a:gd name="connsiteY30" fmla="*/ 1769816 h 1934047"/>
              <a:gd name="connsiteX31" fmla="*/ 175162 w 1961799"/>
              <a:gd name="connsiteY31" fmla="*/ 1802663 h 1934047"/>
              <a:gd name="connsiteX32" fmla="*/ 273690 w 1961799"/>
              <a:gd name="connsiteY32" fmla="*/ 1835509 h 1934047"/>
              <a:gd name="connsiteX33" fmla="*/ 339376 w 1961799"/>
              <a:gd name="connsiteY33" fmla="*/ 1857406 h 1934047"/>
              <a:gd name="connsiteX34" fmla="*/ 372219 w 1961799"/>
              <a:gd name="connsiteY34" fmla="*/ 1868355 h 1934047"/>
              <a:gd name="connsiteX35" fmla="*/ 711595 w 1961799"/>
              <a:gd name="connsiteY35" fmla="*/ 1912150 h 1934047"/>
              <a:gd name="connsiteX36" fmla="*/ 766333 w 1961799"/>
              <a:gd name="connsiteY36" fmla="*/ 1923098 h 1934047"/>
              <a:gd name="connsiteX37" fmla="*/ 810124 w 1961799"/>
              <a:gd name="connsiteY37" fmla="*/ 1934047 h 1934047"/>
              <a:gd name="connsiteX38" fmla="*/ 1105710 w 1961799"/>
              <a:gd name="connsiteY38" fmla="*/ 1923098 h 1934047"/>
              <a:gd name="connsiteX39" fmla="*/ 1138552 w 1961799"/>
              <a:gd name="connsiteY39" fmla="*/ 1901201 h 1934047"/>
              <a:gd name="connsiteX40" fmla="*/ 1204238 w 1961799"/>
              <a:gd name="connsiteY40" fmla="*/ 1879304 h 1934047"/>
              <a:gd name="connsiteX41" fmla="*/ 1357505 w 1961799"/>
              <a:gd name="connsiteY41" fmla="*/ 1857406 h 1934047"/>
              <a:gd name="connsiteX42" fmla="*/ 1390348 w 1961799"/>
              <a:gd name="connsiteY42" fmla="*/ 1846457 h 1934047"/>
              <a:gd name="connsiteX43" fmla="*/ 1434138 w 1961799"/>
              <a:gd name="connsiteY43" fmla="*/ 1835509 h 1934047"/>
              <a:gd name="connsiteX44" fmla="*/ 1466981 w 1961799"/>
              <a:gd name="connsiteY44" fmla="*/ 1813611 h 1934047"/>
              <a:gd name="connsiteX45" fmla="*/ 1510772 w 1961799"/>
              <a:gd name="connsiteY45" fmla="*/ 1791714 h 1934047"/>
              <a:gd name="connsiteX46" fmla="*/ 1554562 w 1961799"/>
              <a:gd name="connsiteY46" fmla="*/ 1726022 h 1934047"/>
              <a:gd name="connsiteX47" fmla="*/ 1576457 w 1961799"/>
              <a:gd name="connsiteY47" fmla="*/ 1693175 h 1934047"/>
              <a:gd name="connsiteX48" fmla="*/ 1664038 w 1961799"/>
              <a:gd name="connsiteY48" fmla="*/ 1594637 h 1934047"/>
              <a:gd name="connsiteX49" fmla="*/ 1751619 w 1961799"/>
              <a:gd name="connsiteY49" fmla="*/ 1550842 h 1934047"/>
              <a:gd name="connsiteX50" fmla="*/ 1861095 w 1961799"/>
              <a:gd name="connsiteY50" fmla="*/ 1485150 h 1934047"/>
              <a:gd name="connsiteX51" fmla="*/ 1882991 w 1961799"/>
              <a:gd name="connsiteY51" fmla="*/ 1463252 h 1934047"/>
              <a:gd name="connsiteX52" fmla="*/ 1893938 w 1961799"/>
              <a:gd name="connsiteY52" fmla="*/ 1419458 h 1934047"/>
              <a:gd name="connsiteX53" fmla="*/ 1915834 w 1961799"/>
              <a:gd name="connsiteY53" fmla="*/ 1386611 h 1934047"/>
              <a:gd name="connsiteX54" fmla="*/ 1926781 w 1961799"/>
              <a:gd name="connsiteY54" fmla="*/ 1331868 h 1934047"/>
              <a:gd name="connsiteX55" fmla="*/ 1948676 w 1961799"/>
              <a:gd name="connsiteY55" fmla="*/ 1266176 h 1934047"/>
              <a:gd name="connsiteX56" fmla="*/ 1926781 w 1961799"/>
              <a:gd name="connsiteY56" fmla="*/ 1090996 h 1934047"/>
              <a:gd name="connsiteX57" fmla="*/ 1904886 w 1961799"/>
              <a:gd name="connsiteY57" fmla="*/ 1058150 h 1934047"/>
              <a:gd name="connsiteX58" fmla="*/ 1872043 w 1961799"/>
              <a:gd name="connsiteY58" fmla="*/ 948663 h 1934047"/>
              <a:gd name="connsiteX59" fmla="*/ 1861095 w 1961799"/>
              <a:gd name="connsiteY59" fmla="*/ 904868 h 1934047"/>
              <a:gd name="connsiteX60" fmla="*/ 1872043 w 1961799"/>
              <a:gd name="connsiteY60" fmla="*/ 850125 h 1934047"/>
              <a:gd name="connsiteX61" fmla="*/ 1937729 w 1961799"/>
              <a:gd name="connsiteY61" fmla="*/ 795381 h 1934047"/>
              <a:gd name="connsiteX62" fmla="*/ 1926781 w 1961799"/>
              <a:gd name="connsiteY62" fmla="*/ 368381 h 1934047"/>
              <a:gd name="connsiteX63" fmla="*/ 1904886 w 1961799"/>
              <a:gd name="connsiteY63" fmla="*/ 335535 h 1934047"/>
              <a:gd name="connsiteX64" fmla="*/ 1872043 w 1961799"/>
              <a:gd name="connsiteY64" fmla="*/ 291740 h 1934047"/>
              <a:gd name="connsiteX65" fmla="*/ 1828253 w 1961799"/>
              <a:gd name="connsiteY65" fmla="*/ 226048 h 1934047"/>
              <a:gd name="connsiteX66" fmla="*/ 1751619 w 1961799"/>
              <a:gd name="connsiteY66" fmla="*/ 171304 h 1934047"/>
              <a:gd name="connsiteX67" fmla="*/ 1674986 w 1961799"/>
              <a:gd name="connsiteY67" fmla="*/ 138458 h 1934047"/>
              <a:gd name="connsiteX68" fmla="*/ 1609300 w 1961799"/>
              <a:gd name="connsiteY68" fmla="*/ 116561 h 1934047"/>
              <a:gd name="connsiteX69" fmla="*/ 1510772 w 1961799"/>
              <a:gd name="connsiteY69" fmla="*/ 94663 h 1934047"/>
              <a:gd name="connsiteX70" fmla="*/ 1445086 w 1961799"/>
              <a:gd name="connsiteY70" fmla="*/ 72766 h 1934047"/>
              <a:gd name="connsiteX71" fmla="*/ 1401295 w 1961799"/>
              <a:gd name="connsiteY71" fmla="*/ 50868 h 1934047"/>
              <a:gd name="connsiteX72" fmla="*/ 1335610 w 1961799"/>
              <a:gd name="connsiteY72" fmla="*/ 28971 h 1934047"/>
              <a:gd name="connsiteX73" fmla="*/ 1313714 w 1961799"/>
              <a:gd name="connsiteY73" fmla="*/ 7074 h 1934047"/>
              <a:gd name="connsiteX74" fmla="*/ 1248029 w 1961799"/>
              <a:gd name="connsiteY74" fmla="*/ 7074 h 1934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</a:cxnLst>
            <a:rect l="l" t="t" r="r" b="b"/>
            <a:pathLst>
              <a:path w="1961799" h="1934047">
                <a:moveTo>
                  <a:pt x="1248029" y="7074"/>
                </a:moveTo>
                <a:cubicBezTo>
                  <a:pt x="1198765" y="12548"/>
                  <a:pt x="1070457" y="5032"/>
                  <a:pt x="1018129" y="39920"/>
                </a:cubicBezTo>
                <a:cubicBezTo>
                  <a:pt x="1007181" y="47219"/>
                  <a:pt x="995560" y="53597"/>
                  <a:pt x="985286" y="61817"/>
                </a:cubicBezTo>
                <a:cubicBezTo>
                  <a:pt x="977226" y="68266"/>
                  <a:pt x="971451" y="77266"/>
                  <a:pt x="963391" y="83715"/>
                </a:cubicBezTo>
                <a:cubicBezTo>
                  <a:pt x="880018" y="150421"/>
                  <a:pt x="992182" y="43972"/>
                  <a:pt x="886757" y="149407"/>
                </a:cubicBezTo>
                <a:lnTo>
                  <a:pt x="853914" y="182253"/>
                </a:lnTo>
                <a:cubicBezTo>
                  <a:pt x="850265" y="193202"/>
                  <a:pt x="851127" y="206938"/>
                  <a:pt x="842967" y="215099"/>
                </a:cubicBezTo>
                <a:cubicBezTo>
                  <a:pt x="754911" y="303163"/>
                  <a:pt x="772493" y="272579"/>
                  <a:pt x="700648" y="313638"/>
                </a:cubicBezTo>
                <a:cubicBezTo>
                  <a:pt x="575278" y="385286"/>
                  <a:pt x="770828" y="277795"/>
                  <a:pt x="634962" y="368381"/>
                </a:cubicBezTo>
                <a:cubicBezTo>
                  <a:pt x="625360" y="374783"/>
                  <a:pt x="612440" y="374169"/>
                  <a:pt x="602119" y="379330"/>
                </a:cubicBezTo>
                <a:cubicBezTo>
                  <a:pt x="571634" y="394574"/>
                  <a:pt x="560645" y="409859"/>
                  <a:pt x="536433" y="434073"/>
                </a:cubicBezTo>
                <a:cubicBezTo>
                  <a:pt x="521836" y="463270"/>
                  <a:pt x="510748" y="494502"/>
                  <a:pt x="492643" y="521663"/>
                </a:cubicBezTo>
                <a:cubicBezTo>
                  <a:pt x="485345" y="532612"/>
                  <a:pt x="481022" y="546289"/>
                  <a:pt x="470748" y="554509"/>
                </a:cubicBezTo>
                <a:cubicBezTo>
                  <a:pt x="461737" y="561718"/>
                  <a:pt x="448853" y="561808"/>
                  <a:pt x="437905" y="565458"/>
                </a:cubicBezTo>
                <a:cubicBezTo>
                  <a:pt x="430607" y="587355"/>
                  <a:pt x="421608" y="608757"/>
                  <a:pt x="416010" y="631150"/>
                </a:cubicBezTo>
                <a:cubicBezTo>
                  <a:pt x="412361" y="645748"/>
                  <a:pt x="414970" y="663620"/>
                  <a:pt x="405062" y="674945"/>
                </a:cubicBezTo>
                <a:cubicBezTo>
                  <a:pt x="387734" y="694750"/>
                  <a:pt x="357983" y="700131"/>
                  <a:pt x="339376" y="718740"/>
                </a:cubicBezTo>
                <a:cubicBezTo>
                  <a:pt x="328428" y="729689"/>
                  <a:pt x="316444" y="739691"/>
                  <a:pt x="306533" y="751586"/>
                </a:cubicBezTo>
                <a:cubicBezTo>
                  <a:pt x="282286" y="780685"/>
                  <a:pt x="282211" y="794155"/>
                  <a:pt x="262743" y="828227"/>
                </a:cubicBezTo>
                <a:cubicBezTo>
                  <a:pt x="256215" y="839652"/>
                  <a:pt x="248146" y="850124"/>
                  <a:pt x="240848" y="861073"/>
                </a:cubicBezTo>
                <a:cubicBezTo>
                  <a:pt x="238271" y="871382"/>
                  <a:pt x="226092" y="924862"/>
                  <a:pt x="218952" y="937714"/>
                </a:cubicBezTo>
                <a:cubicBezTo>
                  <a:pt x="206173" y="960719"/>
                  <a:pt x="189759" y="981509"/>
                  <a:pt x="175162" y="1003406"/>
                </a:cubicBezTo>
                <a:cubicBezTo>
                  <a:pt x="167864" y="1014355"/>
                  <a:pt x="157428" y="1023770"/>
                  <a:pt x="153267" y="1036253"/>
                </a:cubicBezTo>
                <a:cubicBezTo>
                  <a:pt x="137423" y="1083788"/>
                  <a:pt x="150479" y="1060938"/>
                  <a:pt x="109476" y="1101945"/>
                </a:cubicBezTo>
                <a:lnTo>
                  <a:pt x="87581" y="1167637"/>
                </a:lnTo>
                <a:cubicBezTo>
                  <a:pt x="83932" y="1178586"/>
                  <a:pt x="78896" y="1189166"/>
                  <a:pt x="76633" y="1200483"/>
                </a:cubicBezTo>
                <a:cubicBezTo>
                  <a:pt x="69335" y="1236979"/>
                  <a:pt x="63764" y="1273863"/>
                  <a:pt x="54738" y="1309970"/>
                </a:cubicBezTo>
                <a:cubicBezTo>
                  <a:pt x="20512" y="1446882"/>
                  <a:pt x="64254" y="1276660"/>
                  <a:pt x="32843" y="1386611"/>
                </a:cubicBezTo>
                <a:cubicBezTo>
                  <a:pt x="-244" y="1502429"/>
                  <a:pt x="52026" y="1340002"/>
                  <a:pt x="0" y="1496099"/>
                </a:cubicBezTo>
                <a:cubicBezTo>
                  <a:pt x="7298" y="1558142"/>
                  <a:pt x="1374" y="1623223"/>
                  <a:pt x="21895" y="1682227"/>
                </a:cubicBezTo>
                <a:cubicBezTo>
                  <a:pt x="42302" y="1740902"/>
                  <a:pt x="89829" y="1743850"/>
                  <a:pt x="131371" y="1769816"/>
                </a:cubicBezTo>
                <a:cubicBezTo>
                  <a:pt x="146844" y="1779488"/>
                  <a:pt x="159212" y="1793801"/>
                  <a:pt x="175162" y="1802663"/>
                </a:cubicBezTo>
                <a:cubicBezTo>
                  <a:pt x="218104" y="1826522"/>
                  <a:pt x="230562" y="1822569"/>
                  <a:pt x="273690" y="1835509"/>
                </a:cubicBezTo>
                <a:cubicBezTo>
                  <a:pt x="295796" y="1842142"/>
                  <a:pt x="317481" y="1850107"/>
                  <a:pt x="339376" y="1857406"/>
                </a:cubicBezTo>
                <a:cubicBezTo>
                  <a:pt x="350324" y="1861056"/>
                  <a:pt x="360820" y="1866555"/>
                  <a:pt x="372219" y="1868355"/>
                </a:cubicBezTo>
                <a:cubicBezTo>
                  <a:pt x="623628" y="1908055"/>
                  <a:pt x="510272" y="1895371"/>
                  <a:pt x="711595" y="1912150"/>
                </a:cubicBezTo>
                <a:cubicBezTo>
                  <a:pt x="729841" y="1915799"/>
                  <a:pt x="748169" y="1919061"/>
                  <a:pt x="766333" y="1923098"/>
                </a:cubicBezTo>
                <a:cubicBezTo>
                  <a:pt x="781021" y="1926362"/>
                  <a:pt x="795078" y="1934047"/>
                  <a:pt x="810124" y="1934047"/>
                </a:cubicBezTo>
                <a:cubicBezTo>
                  <a:pt x="908720" y="1934047"/>
                  <a:pt x="1007181" y="1926748"/>
                  <a:pt x="1105710" y="1923098"/>
                </a:cubicBezTo>
                <a:cubicBezTo>
                  <a:pt x="1116657" y="1915799"/>
                  <a:pt x="1126529" y="1906545"/>
                  <a:pt x="1138552" y="1901201"/>
                </a:cubicBezTo>
                <a:cubicBezTo>
                  <a:pt x="1159642" y="1891827"/>
                  <a:pt x="1182343" y="1886603"/>
                  <a:pt x="1204238" y="1879304"/>
                </a:cubicBezTo>
                <a:cubicBezTo>
                  <a:pt x="1275322" y="1855607"/>
                  <a:pt x="1225578" y="1869401"/>
                  <a:pt x="1357505" y="1857406"/>
                </a:cubicBezTo>
                <a:cubicBezTo>
                  <a:pt x="1368453" y="1853756"/>
                  <a:pt x="1379252" y="1849628"/>
                  <a:pt x="1390348" y="1846457"/>
                </a:cubicBezTo>
                <a:cubicBezTo>
                  <a:pt x="1404815" y="1842323"/>
                  <a:pt x="1420309" y="1841436"/>
                  <a:pt x="1434138" y="1835509"/>
                </a:cubicBezTo>
                <a:cubicBezTo>
                  <a:pt x="1446232" y="1830325"/>
                  <a:pt x="1455557" y="1820140"/>
                  <a:pt x="1466981" y="1813611"/>
                </a:cubicBezTo>
                <a:cubicBezTo>
                  <a:pt x="1481151" y="1805513"/>
                  <a:pt x="1496175" y="1799013"/>
                  <a:pt x="1510772" y="1791714"/>
                </a:cubicBezTo>
                <a:lnTo>
                  <a:pt x="1554562" y="1726022"/>
                </a:lnTo>
                <a:lnTo>
                  <a:pt x="1576457" y="1693175"/>
                </a:lnTo>
                <a:cubicBezTo>
                  <a:pt x="1599594" y="1658466"/>
                  <a:pt x="1626549" y="1613383"/>
                  <a:pt x="1664038" y="1594637"/>
                </a:cubicBezTo>
                <a:lnTo>
                  <a:pt x="1751619" y="1550842"/>
                </a:lnTo>
                <a:cubicBezTo>
                  <a:pt x="1786178" y="1533561"/>
                  <a:pt x="1834669" y="1511579"/>
                  <a:pt x="1861095" y="1485150"/>
                </a:cubicBezTo>
                <a:lnTo>
                  <a:pt x="1882991" y="1463252"/>
                </a:lnTo>
                <a:cubicBezTo>
                  <a:pt x="1886640" y="1448654"/>
                  <a:pt x="1888011" y="1433289"/>
                  <a:pt x="1893938" y="1419458"/>
                </a:cubicBezTo>
                <a:cubicBezTo>
                  <a:pt x="1899121" y="1407363"/>
                  <a:pt x="1911214" y="1398932"/>
                  <a:pt x="1915834" y="1386611"/>
                </a:cubicBezTo>
                <a:cubicBezTo>
                  <a:pt x="1922367" y="1369187"/>
                  <a:pt x="1921885" y="1349821"/>
                  <a:pt x="1926781" y="1331868"/>
                </a:cubicBezTo>
                <a:cubicBezTo>
                  <a:pt x="1932853" y="1309600"/>
                  <a:pt x="1941378" y="1288073"/>
                  <a:pt x="1948676" y="1266176"/>
                </a:cubicBezTo>
                <a:cubicBezTo>
                  <a:pt x="1941378" y="1207783"/>
                  <a:pt x="1938903" y="1148582"/>
                  <a:pt x="1926781" y="1090996"/>
                </a:cubicBezTo>
                <a:cubicBezTo>
                  <a:pt x="1924071" y="1078120"/>
                  <a:pt x="1908667" y="1070753"/>
                  <a:pt x="1904886" y="1058150"/>
                </a:cubicBezTo>
                <a:cubicBezTo>
                  <a:pt x="1866461" y="930054"/>
                  <a:pt x="1921313" y="1022576"/>
                  <a:pt x="1872043" y="948663"/>
                </a:cubicBezTo>
                <a:cubicBezTo>
                  <a:pt x="1868394" y="934065"/>
                  <a:pt x="1861095" y="919916"/>
                  <a:pt x="1861095" y="904868"/>
                </a:cubicBezTo>
                <a:cubicBezTo>
                  <a:pt x="1861095" y="886259"/>
                  <a:pt x="1863721" y="866770"/>
                  <a:pt x="1872043" y="850125"/>
                </a:cubicBezTo>
                <a:cubicBezTo>
                  <a:pt x="1882581" y="829047"/>
                  <a:pt x="1918865" y="807958"/>
                  <a:pt x="1937729" y="795381"/>
                </a:cubicBezTo>
                <a:cubicBezTo>
                  <a:pt x="1978116" y="633806"/>
                  <a:pt x="1963018" y="712667"/>
                  <a:pt x="1926781" y="368381"/>
                </a:cubicBezTo>
                <a:cubicBezTo>
                  <a:pt x="1925404" y="355295"/>
                  <a:pt x="1912534" y="346243"/>
                  <a:pt x="1904886" y="335535"/>
                </a:cubicBezTo>
                <a:cubicBezTo>
                  <a:pt x="1894281" y="320686"/>
                  <a:pt x="1882506" y="306689"/>
                  <a:pt x="1872043" y="291740"/>
                </a:cubicBezTo>
                <a:cubicBezTo>
                  <a:pt x="1856953" y="270180"/>
                  <a:pt x="1851791" y="237818"/>
                  <a:pt x="1828253" y="226048"/>
                </a:cubicBezTo>
                <a:cubicBezTo>
                  <a:pt x="1747221" y="185527"/>
                  <a:pt x="1818195" y="226789"/>
                  <a:pt x="1751619" y="171304"/>
                </a:cubicBezTo>
                <a:cubicBezTo>
                  <a:pt x="1715798" y="141450"/>
                  <a:pt x="1720631" y="152153"/>
                  <a:pt x="1674986" y="138458"/>
                </a:cubicBezTo>
                <a:cubicBezTo>
                  <a:pt x="1652880" y="131825"/>
                  <a:pt x="1631932" y="121088"/>
                  <a:pt x="1609300" y="116561"/>
                </a:cubicBezTo>
                <a:cubicBezTo>
                  <a:pt x="1578043" y="110309"/>
                  <a:pt x="1541697" y="103941"/>
                  <a:pt x="1510772" y="94663"/>
                </a:cubicBezTo>
                <a:cubicBezTo>
                  <a:pt x="1488666" y="88030"/>
                  <a:pt x="1465729" y="83089"/>
                  <a:pt x="1445086" y="72766"/>
                </a:cubicBezTo>
                <a:cubicBezTo>
                  <a:pt x="1430489" y="65467"/>
                  <a:pt x="1416448" y="56930"/>
                  <a:pt x="1401295" y="50868"/>
                </a:cubicBezTo>
                <a:cubicBezTo>
                  <a:pt x="1379866" y="42296"/>
                  <a:pt x="1335610" y="28971"/>
                  <a:pt x="1335610" y="28971"/>
                </a:cubicBezTo>
                <a:cubicBezTo>
                  <a:pt x="1328311" y="21672"/>
                  <a:pt x="1322946" y="11691"/>
                  <a:pt x="1313714" y="7074"/>
                </a:cubicBezTo>
                <a:cubicBezTo>
                  <a:pt x="1288278" y="-5645"/>
                  <a:pt x="1297293" y="1600"/>
                  <a:pt x="1248029" y="7074"/>
                </a:cubicBezTo>
                <a:close/>
              </a:path>
            </a:pathLst>
          </a:custGeom>
          <a:noFill/>
          <a:ln>
            <a:solidFill>
              <a:schemeClr val="bg1"/>
            </a:solidFill>
            <a:prstDash val="dash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3</TotalTime>
  <Words>42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bastien Tabaries</dc:creator>
  <cp:lastModifiedBy>Peter Siegel</cp:lastModifiedBy>
  <cp:revision>61</cp:revision>
  <dcterms:created xsi:type="dcterms:W3CDTF">2014-03-25T13:56:48Z</dcterms:created>
  <dcterms:modified xsi:type="dcterms:W3CDTF">2015-01-28T02:56:18Z</dcterms:modified>
</cp:coreProperties>
</file>